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8"/>
  </p:notesMasterIdLst>
  <p:sldIdLst>
    <p:sldId id="303" r:id="rId2"/>
    <p:sldId id="309" r:id="rId3"/>
    <p:sldId id="302" r:id="rId4"/>
    <p:sldId id="305" r:id="rId5"/>
    <p:sldId id="306" r:id="rId6"/>
    <p:sldId id="308" r:id="rId7"/>
  </p:sldIdLst>
  <p:sldSz cx="27432000" cy="3962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590" userDrawn="1">
          <p15:clr>
            <a:srgbClr val="A4A3A4"/>
          </p15:clr>
        </p15:guide>
        <p15:guide id="2" orient="horz" pos="12880" userDrawn="1">
          <p15:clr>
            <a:srgbClr val="A4A3A4"/>
          </p15:clr>
        </p15:guide>
        <p15:guide id="3" pos="3333" userDrawn="1">
          <p15:clr>
            <a:srgbClr val="A4A3A4"/>
          </p15:clr>
        </p15:guide>
        <p15:guide id="4" pos="8186" userDrawn="1">
          <p15:clr>
            <a:srgbClr val="A4A3A4"/>
          </p15:clr>
        </p15:guide>
        <p15:guide id="5" pos="1211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张 瓶" initials="张" lastIdx="1" clrIdx="0">
    <p:extLst>
      <p:ext uri="{19B8F6BF-5375-455C-9EA6-DF929625EA0E}">
        <p15:presenceInfo xmlns:p15="http://schemas.microsoft.com/office/powerpoint/2012/main" userId="4c74ffb16583b932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4B183"/>
    <a:srgbClr val="B4C7E7"/>
    <a:srgbClr val="A9D18E"/>
    <a:srgbClr val="E25ED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25" autoAdjust="0"/>
    <p:restoredTop sz="96327" autoAdjust="0"/>
  </p:normalViewPr>
  <p:slideViewPr>
    <p:cSldViewPr snapToGrid="0" showGuides="1">
      <p:cViewPr varScale="1">
        <p:scale>
          <a:sx n="19" d="100"/>
          <a:sy n="19" d="100"/>
        </p:scale>
        <p:origin x="3156" y="90"/>
      </p:cViewPr>
      <p:guideLst>
        <p:guide orient="horz" pos="3590"/>
        <p:guide orient="horz" pos="12880"/>
        <p:guide pos="3333"/>
        <p:guide pos="8186"/>
        <p:guide pos="12110"/>
      </p:guideLst>
    </p:cSldViewPr>
  </p:slideViewPr>
  <p:notesTextViewPr>
    <p:cViewPr>
      <p:scale>
        <a:sx n="125" d="100"/>
        <a:sy n="125" d="100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0" cy="72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B28663-613A-4C5E-8EC5-37E39CFBDEDB}" type="datetimeFigureOut">
              <a:rPr lang="zh-CN" altLang="en-US" smtClean="0"/>
              <a:t>2024/3/1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A57390-38CA-4E0D-83DF-220D2BAFE0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28483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3657600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1pPr>
    <a:lvl2pPr marL="1828800" algn="l" defTabSz="3657600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2pPr>
    <a:lvl3pPr marL="3657600" algn="l" defTabSz="3657600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3pPr>
    <a:lvl4pPr marL="5486400" algn="l" defTabSz="3657600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4pPr>
    <a:lvl5pPr marL="7315200" algn="l" defTabSz="3657600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5pPr>
    <a:lvl6pPr marL="9144000" algn="l" defTabSz="3657600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6pPr>
    <a:lvl7pPr marL="10972800" algn="l" defTabSz="3657600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7pPr>
    <a:lvl8pPr marL="12801600" algn="l" defTabSz="3657600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8pPr>
    <a:lvl9pPr marL="14630400" algn="l" defTabSz="3657600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JP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A57390-38CA-4E0D-83DF-220D2BAFE083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57435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57400" y="6484764"/>
            <a:ext cx="23317200" cy="13795022"/>
          </a:xfrm>
        </p:spPr>
        <p:txBody>
          <a:bodyPr anchor="b"/>
          <a:lstStyle>
            <a:lvl1pPr algn="ctr">
              <a:defRPr sz="1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429000" y="20811775"/>
            <a:ext cx="20574000" cy="9566625"/>
          </a:xfrm>
        </p:spPr>
        <p:txBody>
          <a:bodyPr/>
          <a:lstStyle>
            <a:lvl1pPr marL="0" indent="0" algn="ctr">
              <a:buNone/>
              <a:defRPr sz="7200"/>
            </a:lvl1pPr>
            <a:lvl2pPr marL="1371600" indent="0" algn="ctr">
              <a:buNone/>
              <a:defRPr sz="6000"/>
            </a:lvl2pPr>
            <a:lvl3pPr marL="2743200" indent="0" algn="ctr">
              <a:buNone/>
              <a:defRPr sz="5400"/>
            </a:lvl3pPr>
            <a:lvl4pPr marL="4114800" indent="0" algn="ctr">
              <a:buNone/>
              <a:defRPr sz="4800"/>
            </a:lvl4pPr>
            <a:lvl5pPr marL="5486400" indent="0" algn="ctr">
              <a:buNone/>
              <a:defRPr sz="4800"/>
            </a:lvl5pPr>
            <a:lvl6pPr marL="6858000" indent="0" algn="ctr">
              <a:buNone/>
              <a:defRPr sz="4800"/>
            </a:lvl6pPr>
            <a:lvl7pPr marL="8229600" indent="0" algn="ctr">
              <a:buNone/>
              <a:defRPr sz="4800"/>
            </a:lvl7pPr>
            <a:lvl8pPr marL="9601200" indent="0" algn="ctr">
              <a:buNone/>
              <a:defRPr sz="4800"/>
            </a:lvl8pPr>
            <a:lvl9pPr marL="10972800" indent="0" algn="ctr">
              <a:buNone/>
              <a:defRPr sz="48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7F229-AA71-4118-83D4-7A9FD0396D94}" type="datetimeFigureOut">
              <a:rPr lang="zh-CN" altLang="en-US" smtClean="0"/>
              <a:t>2024/3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0C3CF-DAD4-453B-B3EB-9C18DFFE5C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1186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7F229-AA71-4118-83D4-7A9FD0396D94}" type="datetimeFigureOut">
              <a:rPr lang="zh-CN" altLang="en-US" smtClean="0"/>
              <a:t>2024/3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0C3CF-DAD4-453B-B3EB-9C18DFFE5C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14492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9631027" y="2109611"/>
            <a:ext cx="5915025" cy="3357950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885952" y="2109611"/>
            <a:ext cx="17402175" cy="3357950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7F229-AA71-4118-83D4-7A9FD0396D94}" type="datetimeFigureOut">
              <a:rPr lang="zh-CN" altLang="en-US" smtClean="0"/>
              <a:t>2024/3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0C3CF-DAD4-453B-B3EB-9C18DFFE5C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43951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7F229-AA71-4118-83D4-7A9FD0396D94}" type="datetimeFigureOut">
              <a:rPr lang="zh-CN" altLang="en-US" smtClean="0"/>
              <a:t>2024/3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0C3CF-DAD4-453B-B3EB-9C18DFFE5C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85589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71664" y="9878495"/>
            <a:ext cx="23660100" cy="16482480"/>
          </a:xfrm>
        </p:spPr>
        <p:txBody>
          <a:bodyPr anchor="b"/>
          <a:lstStyle>
            <a:lvl1pPr>
              <a:defRPr sz="1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71664" y="26516906"/>
            <a:ext cx="23660100" cy="8667747"/>
          </a:xfrm>
        </p:spPr>
        <p:txBody>
          <a:bodyPr/>
          <a:lstStyle>
            <a:lvl1pPr marL="0" indent="0">
              <a:buNone/>
              <a:defRPr sz="7200">
                <a:solidFill>
                  <a:schemeClr val="tx1"/>
                </a:solidFill>
              </a:defRPr>
            </a:lvl1pPr>
            <a:lvl2pPr marL="1371600" indent="0">
              <a:buNone/>
              <a:defRPr sz="6000">
                <a:solidFill>
                  <a:schemeClr val="tx1">
                    <a:tint val="75000"/>
                  </a:schemeClr>
                </a:solidFill>
              </a:defRPr>
            </a:lvl2pPr>
            <a:lvl3pPr marL="2743200" indent="0">
              <a:buNone/>
              <a:defRPr sz="5400">
                <a:solidFill>
                  <a:schemeClr val="tx1">
                    <a:tint val="75000"/>
                  </a:schemeClr>
                </a:solidFill>
              </a:defRPr>
            </a:lvl3pPr>
            <a:lvl4pPr marL="4114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4pPr>
            <a:lvl5pPr marL="54864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5pPr>
            <a:lvl6pPr marL="68580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6pPr>
            <a:lvl7pPr marL="82296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7pPr>
            <a:lvl8pPr marL="96012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8pPr>
            <a:lvl9pPr marL="10972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7F229-AA71-4118-83D4-7A9FD0396D94}" type="datetimeFigureOut">
              <a:rPr lang="zh-CN" altLang="en-US" smtClean="0"/>
              <a:t>2024/3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0C3CF-DAD4-453B-B3EB-9C18DFFE5C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1488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885950" y="10548056"/>
            <a:ext cx="11658600" cy="2514106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887450" y="10548056"/>
            <a:ext cx="11658600" cy="2514106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7F229-AA71-4118-83D4-7A9FD0396D94}" type="datetimeFigureOut">
              <a:rPr lang="zh-CN" altLang="en-US" smtClean="0"/>
              <a:t>2024/3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0C3CF-DAD4-453B-B3EB-9C18DFFE5C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07907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2109620"/>
            <a:ext cx="23660100" cy="765880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9526" y="9713386"/>
            <a:ext cx="11605020" cy="4760380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89526" y="14473767"/>
            <a:ext cx="11605020" cy="2128873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3887452" y="9713386"/>
            <a:ext cx="11662173" cy="4760380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3887452" y="14473767"/>
            <a:ext cx="11662173" cy="2128873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7F229-AA71-4118-83D4-7A9FD0396D94}" type="datetimeFigureOut">
              <a:rPr lang="zh-CN" altLang="en-US" smtClean="0"/>
              <a:t>2024/3/1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0C3CF-DAD4-453B-B3EB-9C18DFFE5C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78973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7F229-AA71-4118-83D4-7A9FD0396D94}" type="datetimeFigureOut">
              <a:rPr lang="zh-CN" altLang="en-US" smtClean="0"/>
              <a:t>2024/3/1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0C3CF-DAD4-453B-B3EB-9C18DFFE5C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99211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7F229-AA71-4118-83D4-7A9FD0396D94}" type="datetimeFigureOut">
              <a:rPr lang="zh-CN" altLang="en-US" smtClean="0"/>
              <a:t>2024/3/1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0C3CF-DAD4-453B-B3EB-9C18DFFE5C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30476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2641600"/>
            <a:ext cx="8847534" cy="92456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1662173" y="5705131"/>
            <a:ext cx="13887450" cy="28158722"/>
          </a:xfrm>
        </p:spPr>
        <p:txBody>
          <a:bodyPr/>
          <a:lstStyle>
            <a:lvl1pPr>
              <a:defRPr sz="9600"/>
            </a:lvl1pPr>
            <a:lvl2pPr>
              <a:defRPr sz="8400"/>
            </a:lvl2pPr>
            <a:lvl3pPr>
              <a:defRPr sz="7200"/>
            </a:lvl3pPr>
            <a:lvl4pPr>
              <a:defRPr sz="6000"/>
            </a:lvl4pPr>
            <a:lvl5pPr>
              <a:defRPr sz="6000"/>
            </a:lvl5pPr>
            <a:lvl6pPr>
              <a:defRPr sz="6000"/>
            </a:lvl6pPr>
            <a:lvl7pPr>
              <a:defRPr sz="6000"/>
            </a:lvl7pPr>
            <a:lvl8pPr>
              <a:defRPr sz="6000"/>
            </a:lvl8pPr>
            <a:lvl9pPr>
              <a:defRPr sz="6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11887200"/>
            <a:ext cx="8847534" cy="22022508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7F229-AA71-4118-83D4-7A9FD0396D94}" type="datetimeFigureOut">
              <a:rPr lang="zh-CN" altLang="en-US" smtClean="0"/>
              <a:t>2024/3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0C3CF-DAD4-453B-B3EB-9C18DFFE5C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04178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2641600"/>
            <a:ext cx="8847534" cy="92456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1662173" y="5705131"/>
            <a:ext cx="13887450" cy="28158722"/>
          </a:xfrm>
        </p:spPr>
        <p:txBody>
          <a:bodyPr anchor="t"/>
          <a:lstStyle>
            <a:lvl1pPr marL="0" indent="0">
              <a:buNone/>
              <a:defRPr sz="9600"/>
            </a:lvl1pPr>
            <a:lvl2pPr marL="1371600" indent="0">
              <a:buNone/>
              <a:defRPr sz="8400"/>
            </a:lvl2pPr>
            <a:lvl3pPr marL="2743200" indent="0">
              <a:buNone/>
              <a:defRPr sz="7200"/>
            </a:lvl3pPr>
            <a:lvl4pPr marL="4114800" indent="0">
              <a:buNone/>
              <a:defRPr sz="6000"/>
            </a:lvl4pPr>
            <a:lvl5pPr marL="5486400" indent="0">
              <a:buNone/>
              <a:defRPr sz="6000"/>
            </a:lvl5pPr>
            <a:lvl6pPr marL="6858000" indent="0">
              <a:buNone/>
              <a:defRPr sz="6000"/>
            </a:lvl6pPr>
            <a:lvl7pPr marL="8229600" indent="0">
              <a:buNone/>
              <a:defRPr sz="6000"/>
            </a:lvl7pPr>
            <a:lvl8pPr marL="9601200" indent="0">
              <a:buNone/>
              <a:defRPr sz="6000"/>
            </a:lvl8pPr>
            <a:lvl9pPr marL="10972800" indent="0">
              <a:buNone/>
              <a:defRPr sz="6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11887200"/>
            <a:ext cx="8847534" cy="22022508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7F229-AA71-4118-83D4-7A9FD0396D94}" type="datetimeFigureOut">
              <a:rPr lang="zh-CN" altLang="en-US" smtClean="0"/>
              <a:t>2024/3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0C3CF-DAD4-453B-B3EB-9C18DFFE5C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07325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885950" y="2109620"/>
            <a:ext cx="23660100" cy="765880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5950" y="10548056"/>
            <a:ext cx="23660100" cy="2514106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885950" y="36725587"/>
            <a:ext cx="6172200" cy="21096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07F229-AA71-4118-83D4-7A9FD0396D94}" type="datetimeFigureOut">
              <a:rPr lang="zh-CN" altLang="en-US" smtClean="0"/>
              <a:t>2024/3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086850" y="36725587"/>
            <a:ext cx="9258300" cy="21096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9373850" y="36725587"/>
            <a:ext cx="6172200" cy="21096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20C3CF-DAD4-453B-B3EB-9C18DFFE5C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16789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2743200" rtl="0" eaLnBrk="1" latinLnBrk="0" hangingPunct="1">
        <a:lnSpc>
          <a:spcPct val="90000"/>
        </a:lnSpc>
        <a:spcBef>
          <a:spcPct val="0"/>
        </a:spcBef>
        <a:buNone/>
        <a:defRPr sz="13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85800" indent="-685800" algn="l" defTabSz="2743200" rtl="0" eaLnBrk="1" latinLnBrk="0" hangingPunct="1">
        <a:lnSpc>
          <a:spcPct val="90000"/>
        </a:lnSpc>
        <a:spcBef>
          <a:spcPts val="3000"/>
        </a:spcBef>
        <a:buFont typeface="Arial" panose="020B0604020202020204" pitchFamily="34" charset="0"/>
        <a:buChar char="•"/>
        <a:defRPr sz="8400" kern="1200">
          <a:solidFill>
            <a:schemeClr val="tx1"/>
          </a:solidFill>
          <a:latin typeface="+mn-lt"/>
          <a:ea typeface="+mn-ea"/>
          <a:cs typeface="+mn-cs"/>
        </a:defRPr>
      </a:lvl1pPr>
      <a:lvl2pPr marL="20574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4290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6000" kern="1200">
          <a:solidFill>
            <a:schemeClr val="tx1"/>
          </a:solidFill>
          <a:latin typeface="+mn-lt"/>
          <a:ea typeface="+mn-ea"/>
          <a:cs typeface="+mn-cs"/>
        </a:defRPr>
      </a:lvl3pPr>
      <a:lvl4pPr marL="48006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61722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75438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9154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102870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16586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2pPr>
      <a:lvl3pPr marL="27432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3pPr>
      <a:lvl4pPr marL="41148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54864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68580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2296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96012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09728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openxmlformats.org/officeDocument/2006/relationships/image" Target="../media/image6.emf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oleObject" Target="../embeddings/oleObject2.bin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openxmlformats.org/officeDocument/2006/relationships/image" Target="../media/image5.emf"/><Relationship Id="rId5" Type="http://schemas.microsoft.com/office/2007/relationships/hdphoto" Target="../media/hdphoto2.wdp"/><Relationship Id="rId15" Type="http://schemas.openxmlformats.org/officeDocument/2006/relationships/image" Target="../media/image7.emf"/><Relationship Id="rId10" Type="http://schemas.openxmlformats.org/officeDocument/2006/relationships/oleObject" Target="../embeddings/oleObject1.bin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oleObject" Target="../embeddings/oleObject3.bin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emf"/><Relationship Id="rId4" Type="http://schemas.openxmlformats.org/officeDocument/2006/relationships/oleObject" Target="../embeddings/oleObject5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23">
            <a:extLst>
              <a:ext uri="{FF2B5EF4-FFF2-40B4-BE49-F238E27FC236}">
                <a16:creationId xmlns:a16="http://schemas.microsoft.com/office/drawing/2014/main" id="{90A61A76-5E71-0726-64B1-CCB4DC02BEDE}"/>
              </a:ext>
            </a:extLst>
          </p:cNvPr>
          <p:cNvSpPr txBox="1"/>
          <p:nvPr/>
        </p:nvSpPr>
        <p:spPr>
          <a:xfrm>
            <a:off x="544898" y="54558"/>
            <a:ext cx="1021433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5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zh-CN" altLang="en-US" sz="5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9">
            <a:extLst>
              <a:ext uri="{FF2B5EF4-FFF2-40B4-BE49-F238E27FC236}">
                <a16:creationId xmlns:a16="http://schemas.microsoft.com/office/drawing/2014/main" id="{64263FFA-4DA6-EFE4-925B-3904C5D9F4D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8000"/>
                    </a14:imgEffect>
                    <a14:imgEffect>
                      <a14:brightnessContrast bright="1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614" t="22661" r="6245" b="45293"/>
          <a:stretch/>
        </p:blipFill>
        <p:spPr>
          <a:xfrm rot="162900">
            <a:off x="2044286" y="17479610"/>
            <a:ext cx="13839308" cy="4461860"/>
          </a:xfrm>
          <a:prstGeom prst="rect">
            <a:avLst/>
          </a:prstGeom>
        </p:spPr>
      </p:pic>
      <p:pic>
        <p:nvPicPr>
          <p:cNvPr id="4" name="图片 10">
            <a:extLst>
              <a:ext uri="{FF2B5EF4-FFF2-40B4-BE49-F238E27FC236}">
                <a16:creationId xmlns:a16="http://schemas.microsoft.com/office/drawing/2014/main" id="{4A8169E5-04B7-B287-8DCC-558174288D5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6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073" t="55083" r="25701" b="30644"/>
          <a:stretch/>
        </p:blipFill>
        <p:spPr>
          <a:xfrm>
            <a:off x="2053222" y="22679868"/>
            <a:ext cx="13047532" cy="4521000"/>
          </a:xfrm>
          <a:prstGeom prst="rect">
            <a:avLst/>
          </a:prstGeom>
        </p:spPr>
      </p:pic>
      <p:pic>
        <p:nvPicPr>
          <p:cNvPr id="5" name="图片 11">
            <a:extLst>
              <a:ext uri="{FF2B5EF4-FFF2-40B4-BE49-F238E27FC236}">
                <a16:creationId xmlns:a16="http://schemas.microsoft.com/office/drawing/2014/main" id="{3C9AF4C8-3CA9-EBA9-B1AB-3991481D8D0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89000"/>
                    </a14:imgEffect>
                    <a14:imgEffect>
                      <a14:brightnessContrast bright="1000" contrast="-2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263" t="32798" r="32211" b="55071"/>
          <a:stretch>
            <a:fillRect/>
          </a:stretch>
        </p:blipFill>
        <p:spPr>
          <a:xfrm rot="21540000">
            <a:off x="2522858" y="28188844"/>
            <a:ext cx="12120644" cy="3825896"/>
          </a:xfrm>
          <a:custGeom>
            <a:avLst/>
            <a:gdLst>
              <a:gd name="connsiteX0" fmla="*/ 0 w 2212886"/>
              <a:gd name="connsiteY0" fmla="*/ 0 h 698500"/>
              <a:gd name="connsiteX1" fmla="*/ 2212886 w 2212886"/>
              <a:gd name="connsiteY1" fmla="*/ 0 h 698500"/>
              <a:gd name="connsiteX2" fmla="*/ 2212886 w 2212886"/>
              <a:gd name="connsiteY2" fmla="*/ 698500 h 698500"/>
              <a:gd name="connsiteX3" fmla="*/ 0 w 2212886"/>
              <a:gd name="connsiteY3" fmla="*/ 698500 h 698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212886" h="698500">
                <a:moveTo>
                  <a:pt x="0" y="0"/>
                </a:moveTo>
                <a:lnTo>
                  <a:pt x="2212886" y="0"/>
                </a:lnTo>
                <a:lnTo>
                  <a:pt x="2212886" y="698500"/>
                </a:lnTo>
                <a:lnTo>
                  <a:pt x="0" y="698500"/>
                </a:lnTo>
                <a:close/>
              </a:path>
            </a:pathLst>
          </a:custGeom>
        </p:spPr>
      </p:pic>
      <p:pic>
        <p:nvPicPr>
          <p:cNvPr id="6" name="图片 12">
            <a:extLst>
              <a:ext uri="{FF2B5EF4-FFF2-40B4-BE49-F238E27FC236}">
                <a16:creationId xmlns:a16="http://schemas.microsoft.com/office/drawing/2014/main" id="{EA5413DC-01AF-E455-2045-E272FC6E5BD6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43000"/>
                    </a14:imgEffect>
                    <a14:imgEffect>
                      <a14:brightnessContrast bright="1000" contrast="1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894" t="9282" r="31042" b="77252"/>
          <a:stretch>
            <a:fillRect/>
          </a:stretch>
        </p:blipFill>
        <p:spPr>
          <a:xfrm rot="120000">
            <a:off x="2369770" y="33620968"/>
            <a:ext cx="12226068" cy="4239384"/>
          </a:xfrm>
          <a:custGeom>
            <a:avLst/>
            <a:gdLst>
              <a:gd name="connsiteX0" fmla="*/ 2211538 w 2235916"/>
              <a:gd name="connsiteY0" fmla="*/ 0 h 775303"/>
              <a:gd name="connsiteX1" fmla="*/ 2235916 w 2235916"/>
              <a:gd name="connsiteY1" fmla="*/ 698074 h 775303"/>
              <a:gd name="connsiteX2" fmla="*/ 24378 w 2235916"/>
              <a:gd name="connsiteY2" fmla="*/ 775303 h 775303"/>
              <a:gd name="connsiteX3" fmla="*/ 0 w 2235916"/>
              <a:gd name="connsiteY3" fmla="*/ 77228 h 77530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235916" h="775303">
                <a:moveTo>
                  <a:pt x="2211538" y="0"/>
                </a:moveTo>
                <a:lnTo>
                  <a:pt x="2235916" y="698074"/>
                </a:lnTo>
                <a:lnTo>
                  <a:pt x="24378" y="775303"/>
                </a:lnTo>
                <a:lnTo>
                  <a:pt x="0" y="77228"/>
                </a:lnTo>
                <a:close/>
              </a:path>
            </a:pathLst>
          </a:custGeom>
        </p:spPr>
      </p:pic>
      <p:sp>
        <p:nvSpPr>
          <p:cNvPr id="7" name="文本框 13">
            <a:extLst>
              <a:ext uri="{FF2B5EF4-FFF2-40B4-BE49-F238E27FC236}">
                <a16:creationId xmlns:a16="http://schemas.microsoft.com/office/drawing/2014/main" id="{13138DB8-DC97-0082-F1D0-4CE07814BBBE}"/>
              </a:ext>
            </a:extLst>
          </p:cNvPr>
          <p:cNvSpPr txBox="1"/>
          <p:nvPr/>
        </p:nvSpPr>
        <p:spPr>
          <a:xfrm>
            <a:off x="1543896" y="16838974"/>
            <a:ext cx="2034531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4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-M0</a:t>
            </a:r>
          </a:p>
        </p:txBody>
      </p:sp>
      <p:sp>
        <p:nvSpPr>
          <p:cNvPr id="8" name="矩形 14">
            <a:extLst>
              <a:ext uri="{FF2B5EF4-FFF2-40B4-BE49-F238E27FC236}">
                <a16:creationId xmlns:a16="http://schemas.microsoft.com/office/drawing/2014/main" id="{6C05ACFB-C723-9A01-8AC6-1E5B80F6E362}"/>
              </a:ext>
            </a:extLst>
          </p:cNvPr>
          <p:cNvSpPr/>
          <p:nvPr/>
        </p:nvSpPr>
        <p:spPr>
          <a:xfrm>
            <a:off x="2063568" y="17607852"/>
            <a:ext cx="12366576" cy="4208424"/>
          </a:xfrm>
          <a:prstGeom prst="rect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 sz="4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15">
            <a:extLst>
              <a:ext uri="{FF2B5EF4-FFF2-40B4-BE49-F238E27FC236}">
                <a16:creationId xmlns:a16="http://schemas.microsoft.com/office/drawing/2014/main" id="{FE85306C-1BE8-508E-DC87-15A058950043}"/>
              </a:ext>
            </a:extLst>
          </p:cNvPr>
          <p:cNvSpPr txBox="1"/>
          <p:nvPr/>
        </p:nvSpPr>
        <p:spPr>
          <a:xfrm>
            <a:off x="1533554" y="32895918"/>
            <a:ext cx="4878259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4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-M1+50w MSCs</a:t>
            </a:r>
          </a:p>
        </p:txBody>
      </p:sp>
      <p:sp>
        <p:nvSpPr>
          <p:cNvPr id="10" name="矩形 16">
            <a:extLst>
              <a:ext uri="{FF2B5EF4-FFF2-40B4-BE49-F238E27FC236}">
                <a16:creationId xmlns:a16="http://schemas.microsoft.com/office/drawing/2014/main" id="{119FB08C-FAC5-7EA6-D618-A50D31D55849}"/>
              </a:ext>
            </a:extLst>
          </p:cNvPr>
          <p:cNvSpPr/>
          <p:nvPr/>
        </p:nvSpPr>
        <p:spPr>
          <a:xfrm>
            <a:off x="2053220" y="33664796"/>
            <a:ext cx="12366576" cy="4208424"/>
          </a:xfrm>
          <a:prstGeom prst="rect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 sz="4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7">
            <a:extLst>
              <a:ext uri="{FF2B5EF4-FFF2-40B4-BE49-F238E27FC236}">
                <a16:creationId xmlns:a16="http://schemas.microsoft.com/office/drawing/2014/main" id="{2541B012-C08B-DAF0-C769-A264DDAE120F}"/>
              </a:ext>
            </a:extLst>
          </p:cNvPr>
          <p:cNvSpPr txBox="1"/>
          <p:nvPr/>
        </p:nvSpPr>
        <p:spPr>
          <a:xfrm>
            <a:off x="1543898" y="27463458"/>
            <a:ext cx="4596130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4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-M1+5w MSCs</a:t>
            </a:r>
          </a:p>
        </p:txBody>
      </p:sp>
      <p:sp>
        <p:nvSpPr>
          <p:cNvPr id="12" name="矩形 18">
            <a:extLst>
              <a:ext uri="{FF2B5EF4-FFF2-40B4-BE49-F238E27FC236}">
                <a16:creationId xmlns:a16="http://schemas.microsoft.com/office/drawing/2014/main" id="{580BF925-239B-1867-AB0C-C1723842EBE5}"/>
              </a:ext>
            </a:extLst>
          </p:cNvPr>
          <p:cNvSpPr/>
          <p:nvPr/>
        </p:nvSpPr>
        <p:spPr>
          <a:xfrm>
            <a:off x="2063568" y="28232336"/>
            <a:ext cx="12366576" cy="4208424"/>
          </a:xfrm>
          <a:prstGeom prst="rect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 sz="4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9">
            <a:extLst>
              <a:ext uri="{FF2B5EF4-FFF2-40B4-BE49-F238E27FC236}">
                <a16:creationId xmlns:a16="http://schemas.microsoft.com/office/drawing/2014/main" id="{61A7AFC1-BAB6-B379-B59C-90B8A35880F2}"/>
              </a:ext>
            </a:extLst>
          </p:cNvPr>
          <p:cNvSpPr txBox="1"/>
          <p:nvPr/>
        </p:nvSpPr>
        <p:spPr>
          <a:xfrm>
            <a:off x="1533548" y="22147838"/>
            <a:ext cx="2034531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4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-M1</a:t>
            </a:r>
          </a:p>
        </p:txBody>
      </p:sp>
      <p:sp>
        <p:nvSpPr>
          <p:cNvPr id="14" name="矩形 20">
            <a:extLst>
              <a:ext uri="{FF2B5EF4-FFF2-40B4-BE49-F238E27FC236}">
                <a16:creationId xmlns:a16="http://schemas.microsoft.com/office/drawing/2014/main" id="{32BAB97F-F0F1-BB1C-C72A-61326E7D2021}"/>
              </a:ext>
            </a:extLst>
          </p:cNvPr>
          <p:cNvSpPr/>
          <p:nvPr/>
        </p:nvSpPr>
        <p:spPr>
          <a:xfrm>
            <a:off x="2053220" y="22916720"/>
            <a:ext cx="12366576" cy="4208424"/>
          </a:xfrm>
          <a:prstGeom prst="rect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 sz="4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23">
            <a:extLst>
              <a:ext uri="{FF2B5EF4-FFF2-40B4-BE49-F238E27FC236}">
                <a16:creationId xmlns:a16="http://schemas.microsoft.com/office/drawing/2014/main" id="{5490EC51-31F2-0FCA-0384-F7DB8B4963B7}"/>
              </a:ext>
            </a:extLst>
          </p:cNvPr>
          <p:cNvSpPr txBox="1"/>
          <p:nvPr/>
        </p:nvSpPr>
        <p:spPr>
          <a:xfrm>
            <a:off x="544898" y="15871770"/>
            <a:ext cx="1061509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5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zh-CN" altLang="en-US" sz="5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6" name="Object 11">
            <a:extLst>
              <a:ext uri="{FF2B5EF4-FFF2-40B4-BE49-F238E27FC236}">
                <a16:creationId xmlns:a16="http://schemas.microsoft.com/office/drawing/2014/main" id="{6F1FDB66-A830-0346-0584-EDF772A43ED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87783108"/>
              </p:ext>
            </p:extLst>
          </p:nvPr>
        </p:nvGraphicFramePr>
        <p:xfrm>
          <a:off x="2100263" y="6978904"/>
          <a:ext cx="10287000" cy="8420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2572089" imgH="2105461" progId="Prism10.Document">
                  <p:embed/>
                </p:oleObj>
              </mc:Choice>
              <mc:Fallback>
                <p:oleObj name="Prism 10" r:id="rId10" imgW="2572089" imgH="2105461" progId="Prism10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36787CE6-A2F9-4E76-ACC9-BB852CAADFA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100263" y="6978904"/>
                        <a:ext cx="10287000" cy="8420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2">
            <a:extLst>
              <a:ext uri="{FF2B5EF4-FFF2-40B4-BE49-F238E27FC236}">
                <a16:creationId xmlns:a16="http://schemas.microsoft.com/office/drawing/2014/main" id="{303D16D0-F98D-25E2-A730-366FE729CAF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53116029"/>
              </p:ext>
            </p:extLst>
          </p:nvPr>
        </p:nvGraphicFramePr>
        <p:xfrm>
          <a:off x="10694988" y="6890004"/>
          <a:ext cx="8794750" cy="8604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2198268" imgH="2151200" progId="Prism9.Document">
                  <p:embed/>
                </p:oleObj>
              </mc:Choice>
              <mc:Fallback>
                <p:oleObj name="Prism 9" r:id="rId12" imgW="2198268" imgH="2151200" progId="Prism9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5AAEAF50-15B5-4797-BD4C-01B7E680332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0694988" y="6890004"/>
                        <a:ext cx="8794750" cy="8604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3">
            <a:extLst>
              <a:ext uri="{FF2B5EF4-FFF2-40B4-BE49-F238E27FC236}">
                <a16:creationId xmlns:a16="http://schemas.microsoft.com/office/drawing/2014/main" id="{421814AD-7A32-5E37-91F0-1F7C68892A7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30037891"/>
              </p:ext>
            </p:extLst>
          </p:nvPr>
        </p:nvGraphicFramePr>
        <p:xfrm>
          <a:off x="18314632" y="6890623"/>
          <a:ext cx="8794752" cy="86042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4" imgW="2198268" imgH="2151200" progId="Prism9.Document">
                  <p:embed/>
                </p:oleObj>
              </mc:Choice>
              <mc:Fallback>
                <p:oleObj name="Prism 9" r:id="rId14" imgW="2198268" imgH="2151200" progId="Prism9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7355F125-A072-4697-968B-5D01D203838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18314632" y="6890623"/>
                        <a:ext cx="8794752" cy="86042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9" name="图片 18">
            <a:extLst>
              <a:ext uri="{FF2B5EF4-FFF2-40B4-BE49-F238E27FC236}">
                <a16:creationId xmlns:a16="http://schemas.microsoft.com/office/drawing/2014/main" id="{FF13ADAF-EB9A-DECD-01BF-F5EB763236AB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66" r="30671" b="3201"/>
          <a:stretch/>
        </p:blipFill>
        <p:spPr>
          <a:xfrm>
            <a:off x="17695140" y="17517746"/>
            <a:ext cx="9430632" cy="18848604"/>
          </a:xfrm>
          <a:prstGeom prst="rect">
            <a:avLst/>
          </a:prstGeom>
        </p:spPr>
      </p:pic>
      <p:graphicFrame>
        <p:nvGraphicFramePr>
          <p:cNvPr id="20" name="表格 19">
            <a:extLst>
              <a:ext uri="{FF2B5EF4-FFF2-40B4-BE49-F238E27FC236}">
                <a16:creationId xmlns:a16="http://schemas.microsoft.com/office/drawing/2014/main" id="{D6CB5AD7-9623-2A42-F5C3-810A4579DD2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34116143"/>
              </p:ext>
            </p:extLst>
          </p:nvPr>
        </p:nvGraphicFramePr>
        <p:xfrm>
          <a:off x="15114926" y="17607852"/>
          <a:ext cx="2381652" cy="1839200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381652">
                  <a:extLst>
                    <a:ext uri="{9D8B030D-6E8A-4147-A177-3AD203B41FA5}">
                      <a16:colId xmlns:a16="http://schemas.microsoft.com/office/drawing/2014/main" val="4126351506"/>
                    </a:ext>
                  </a:extLst>
                </a:gridCol>
              </a:tblGrid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-1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1216547913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F-</a:t>
                      </a:r>
                      <a:r>
                        <a:rPr lang="en-US" altLang="zh-CN" sz="2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α</a:t>
                      </a:r>
                      <a:endParaRPr lang="en-US" sz="2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1843403803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MP-1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3264762210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RC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2655845108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DF-1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2025577161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TES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3380678979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P-2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3089624615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P-1b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3736906381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P-1a</a:t>
                      </a:r>
                      <a:endParaRPr lang="en-US" sz="2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1088726270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G</a:t>
                      </a:r>
                      <a:endParaRPr lang="en-US" sz="2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1900480114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P-5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253522109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E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1611780479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-CSF</a:t>
                      </a:r>
                      <a:endParaRPr lang="en-US" sz="2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230341991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C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4222467024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-TAC</a:t>
                      </a:r>
                      <a:endParaRPr lang="en-US" sz="2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1588868192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P-10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20274402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27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3882439720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23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1372260596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17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2550939481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16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3067165598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12p70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2123639392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13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651509012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10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471335949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7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3501674424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6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2137241561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5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2643253295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4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1539148107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3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1938257123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2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1146243855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1ra</a:t>
                      </a:r>
                      <a:endParaRPr lang="en-US" sz="2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41999216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1</a:t>
                      </a:r>
                      <a:r>
                        <a:rPr lang="en-US" altLang="zh-CN" sz="2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</a:t>
                      </a:r>
                      <a:endParaRPr lang="en-US" sz="2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3199677290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1</a:t>
                      </a:r>
                      <a:r>
                        <a:rPr lang="en-US" altLang="zh-CN" sz="2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α</a:t>
                      </a:r>
                      <a:endParaRPr lang="en-US" sz="2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752877230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FN-y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93054546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CAM-1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1683739201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otaxin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742005207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-309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659045600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M-CSF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2959617865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-CSF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4177116157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5</a:t>
                      </a:r>
                      <a:r>
                        <a:rPr lang="en-US" sz="2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sz="2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5a</a:t>
                      </a:r>
                      <a:endParaRPr lang="en-US" sz="2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3465962085"/>
                  </a:ext>
                </a:extLst>
              </a:tr>
              <a:tr h="459800">
                <a:tc>
                  <a:txBody>
                    <a:bodyPr/>
                    <a:lstStyle/>
                    <a:p>
                      <a:pPr algn="r" fontAlgn="b"/>
                      <a:r>
                        <a:rPr lang="en-US" sz="2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C</a:t>
                      </a:r>
                      <a:endParaRPr lang="en-US" sz="2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3080" marR="33080" marT="33080" marB="0" anchor="b"/>
                </a:tc>
                <a:extLst>
                  <a:ext uri="{0D108BD9-81ED-4DB2-BD59-A6C34878D82A}">
                    <a16:rowId xmlns:a16="http://schemas.microsoft.com/office/drawing/2014/main" val="2180403483"/>
                  </a:ext>
                </a:extLst>
              </a:tr>
            </a:tbl>
          </a:graphicData>
        </a:graphic>
      </p:graphicFrame>
      <p:graphicFrame>
        <p:nvGraphicFramePr>
          <p:cNvPr id="21" name="表格 8">
            <a:extLst>
              <a:ext uri="{FF2B5EF4-FFF2-40B4-BE49-F238E27FC236}">
                <a16:creationId xmlns:a16="http://schemas.microsoft.com/office/drawing/2014/main" id="{49E1202F-CB35-C955-208C-C639661C131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92832947"/>
              </p:ext>
            </p:extLst>
          </p:nvPr>
        </p:nvGraphicFramePr>
        <p:xfrm>
          <a:off x="18181356" y="36149384"/>
          <a:ext cx="8611664" cy="12192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983744">
                  <a:extLst>
                    <a:ext uri="{9D8B030D-6E8A-4147-A177-3AD203B41FA5}">
                      <a16:colId xmlns:a16="http://schemas.microsoft.com/office/drawing/2014/main" val="1226344386"/>
                    </a:ext>
                  </a:extLst>
                </a:gridCol>
                <a:gridCol w="1981200">
                  <a:extLst>
                    <a:ext uri="{9D8B030D-6E8A-4147-A177-3AD203B41FA5}">
                      <a16:colId xmlns:a16="http://schemas.microsoft.com/office/drawing/2014/main" val="613361493"/>
                    </a:ext>
                  </a:extLst>
                </a:gridCol>
                <a:gridCol w="2260600">
                  <a:extLst>
                    <a:ext uri="{9D8B030D-6E8A-4147-A177-3AD203B41FA5}">
                      <a16:colId xmlns:a16="http://schemas.microsoft.com/office/drawing/2014/main" val="1442652308"/>
                    </a:ext>
                  </a:extLst>
                </a:gridCol>
                <a:gridCol w="2386120">
                  <a:extLst>
                    <a:ext uri="{9D8B030D-6E8A-4147-A177-3AD203B41FA5}">
                      <a16:colId xmlns:a16="http://schemas.microsoft.com/office/drawing/2014/main" val="32324715"/>
                    </a:ext>
                  </a:extLst>
                </a:gridCol>
              </a:tblGrid>
              <a:tr h="12192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p-M0</a:t>
                      </a:r>
                      <a:endParaRPr lang="zh-CN" altLang="en-US" sz="2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5760" marR="365760" marT="182880" marB="18288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p-M1</a:t>
                      </a:r>
                      <a:endParaRPr lang="zh-CN" altLang="en-US" sz="2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5760" marR="365760" marT="182880" marB="18288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p-M1+</a:t>
                      </a:r>
                    </a:p>
                    <a:p>
                      <a:pPr algn="ctr"/>
                      <a:r>
                        <a:rPr lang="en-US" altLang="zh-CN" sz="2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w MSCs</a:t>
                      </a:r>
                      <a:endParaRPr lang="zh-CN" altLang="en-US" sz="2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5760" marR="365760" marT="182880" marB="18288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p-M1+</a:t>
                      </a:r>
                    </a:p>
                    <a:p>
                      <a:pPr algn="ctr"/>
                      <a:r>
                        <a:rPr lang="en-US" altLang="zh-CN" sz="2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w MSCs</a:t>
                      </a:r>
                      <a:endParaRPr lang="zh-CN" altLang="en-US" sz="2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5760" marR="365760" marT="182880" marB="182880" anchor="ctr"/>
                </a:tc>
                <a:extLst>
                  <a:ext uri="{0D108BD9-81ED-4DB2-BD59-A6C34878D82A}">
                    <a16:rowId xmlns:a16="http://schemas.microsoft.com/office/drawing/2014/main" val="1523397980"/>
                  </a:ext>
                </a:extLst>
              </a:tr>
            </a:tbl>
          </a:graphicData>
        </a:graphic>
      </p:graphicFrame>
      <p:pic>
        <p:nvPicPr>
          <p:cNvPr id="22" name="图片 21">
            <a:extLst>
              <a:ext uri="{FF2B5EF4-FFF2-40B4-BE49-F238E27FC236}">
                <a16:creationId xmlns:a16="http://schemas.microsoft.com/office/drawing/2014/main" id="{818D2E5D-FED7-4E10-64F7-5770FD00CA95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410" t="38511" r="23007" b="38145"/>
          <a:stretch/>
        </p:blipFill>
        <p:spPr>
          <a:xfrm rot="5400000">
            <a:off x="22904136" y="35414085"/>
            <a:ext cx="1108920" cy="4632576"/>
          </a:xfrm>
          <a:prstGeom prst="rect">
            <a:avLst/>
          </a:prstGeom>
        </p:spPr>
      </p:pic>
      <p:sp>
        <p:nvSpPr>
          <p:cNvPr id="23" name="文本框 22">
            <a:extLst>
              <a:ext uri="{FF2B5EF4-FFF2-40B4-BE49-F238E27FC236}">
                <a16:creationId xmlns:a16="http://schemas.microsoft.com/office/drawing/2014/main" id="{6650FA0A-B013-CA92-CF25-22C513AC6D7D}"/>
              </a:ext>
            </a:extLst>
          </p:cNvPr>
          <p:cNvSpPr txBox="1"/>
          <p:nvPr/>
        </p:nvSpPr>
        <p:spPr>
          <a:xfrm>
            <a:off x="16772227" y="37272551"/>
            <a:ext cx="421140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lvl="1" algn="ctr"/>
            <a:r>
              <a:rPr lang="en-US" altLang="zh-CN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pixel density</a:t>
            </a:r>
            <a:endParaRPr lang="zh-CN" altLang="en-US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213D42F4-5EA4-33CD-3C90-442A4C87719E}"/>
              </a:ext>
            </a:extLst>
          </p:cNvPr>
          <p:cNvSpPr txBox="1"/>
          <p:nvPr/>
        </p:nvSpPr>
        <p:spPr>
          <a:xfrm>
            <a:off x="21087954" y="38214131"/>
            <a:ext cx="523733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073152"/>
            <a:r>
              <a:rPr lang="en-US" altLang="zh-CN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0	0.25	0.50	0.75	1.00</a:t>
            </a:r>
            <a:endParaRPr lang="zh-CN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611CF05B-E683-E801-8809-92248054A52D}"/>
              </a:ext>
            </a:extLst>
          </p:cNvPr>
          <p:cNvSpPr/>
          <p:nvPr/>
        </p:nvSpPr>
        <p:spPr>
          <a:xfrm>
            <a:off x="2708394" y="18120168"/>
            <a:ext cx="945588" cy="446696"/>
          </a:xfrm>
          <a:prstGeom prst="rect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 sz="28800"/>
          </a:p>
        </p:txBody>
      </p: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46AC09C2-AE38-B423-5370-FDDC62522A00}"/>
              </a:ext>
            </a:extLst>
          </p:cNvPr>
          <p:cNvCxnSpPr>
            <a:cxnSpLocks/>
            <a:stCxn id="25" idx="0"/>
            <a:endCxn id="27" idx="2"/>
          </p:cNvCxnSpPr>
          <p:nvPr/>
        </p:nvCxnSpPr>
        <p:spPr>
          <a:xfrm flipV="1">
            <a:off x="3181188" y="17262704"/>
            <a:ext cx="1783448" cy="85746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文本框 26">
            <a:extLst>
              <a:ext uri="{FF2B5EF4-FFF2-40B4-BE49-F238E27FC236}">
                <a16:creationId xmlns:a16="http://schemas.microsoft.com/office/drawing/2014/main" id="{BDECA9A7-B138-5B20-2CE4-4D00601169FB}"/>
              </a:ext>
            </a:extLst>
          </p:cNvPr>
          <p:cNvSpPr txBox="1"/>
          <p:nvPr/>
        </p:nvSpPr>
        <p:spPr>
          <a:xfrm>
            <a:off x="4075766" y="16677929"/>
            <a:ext cx="1777740" cy="584775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en-US" altLang="zh-CN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f</a:t>
            </a:r>
            <a:endParaRPr lang="zh-CN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EA4AF8F9-7AC5-C338-B13D-A5B27671230F}"/>
              </a:ext>
            </a:extLst>
          </p:cNvPr>
          <p:cNvSpPr/>
          <p:nvPr/>
        </p:nvSpPr>
        <p:spPr>
          <a:xfrm>
            <a:off x="4657954" y="20101600"/>
            <a:ext cx="945588" cy="446696"/>
          </a:xfrm>
          <a:prstGeom prst="rect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 sz="28800"/>
          </a:p>
        </p:txBody>
      </p: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A1CA10EC-C278-1AE5-9EF7-B39F1A29F00E}"/>
              </a:ext>
            </a:extLst>
          </p:cNvPr>
          <p:cNvCxnSpPr>
            <a:cxnSpLocks/>
            <a:stCxn id="28" idx="0"/>
            <a:endCxn id="30" idx="2"/>
          </p:cNvCxnSpPr>
          <p:nvPr/>
        </p:nvCxnSpPr>
        <p:spPr>
          <a:xfrm flipV="1">
            <a:off x="5130748" y="17264686"/>
            <a:ext cx="1385212" cy="283691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文本框 29">
            <a:extLst>
              <a:ext uri="{FF2B5EF4-FFF2-40B4-BE49-F238E27FC236}">
                <a16:creationId xmlns:a16="http://schemas.microsoft.com/office/drawing/2014/main" id="{1211B0E3-F2A5-AF47-1874-D55BCF88665D}"/>
              </a:ext>
            </a:extLst>
          </p:cNvPr>
          <p:cNvSpPr txBox="1"/>
          <p:nvPr/>
        </p:nvSpPr>
        <p:spPr>
          <a:xfrm>
            <a:off x="5466516" y="16679911"/>
            <a:ext cx="2098888" cy="584775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r" fontAlgn="b"/>
            <a:r>
              <a:rPr lang="en-US" altLang="zh-CN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NF-α</a:t>
            </a:r>
            <a:endParaRPr lang="en-US" altLang="zh-CN" sz="3200" dirty="0">
              <a:solidFill>
                <a:srgbClr val="000000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A9B8EF03-725E-A89D-4738-775FCB2B451D}"/>
              </a:ext>
            </a:extLst>
          </p:cNvPr>
          <p:cNvSpPr/>
          <p:nvPr/>
        </p:nvSpPr>
        <p:spPr>
          <a:xfrm>
            <a:off x="11870406" y="18751080"/>
            <a:ext cx="945588" cy="446696"/>
          </a:xfrm>
          <a:prstGeom prst="rect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 sz="28800"/>
          </a:p>
        </p:txBody>
      </p: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DCA1AD05-7204-BDB4-F7FF-09367924D262}"/>
              </a:ext>
            </a:extLst>
          </p:cNvPr>
          <p:cNvCxnSpPr>
            <a:cxnSpLocks/>
            <a:stCxn id="31" idx="0"/>
            <a:endCxn id="33" idx="2"/>
          </p:cNvCxnSpPr>
          <p:nvPr/>
        </p:nvCxnSpPr>
        <p:spPr>
          <a:xfrm flipV="1">
            <a:off x="12343200" y="17287754"/>
            <a:ext cx="427016" cy="146332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文本框 32">
            <a:extLst>
              <a:ext uri="{FF2B5EF4-FFF2-40B4-BE49-F238E27FC236}">
                <a16:creationId xmlns:a16="http://schemas.microsoft.com/office/drawing/2014/main" id="{EB0F4765-1FC6-CF9A-0C86-5F93FF3CD0D1}"/>
              </a:ext>
            </a:extLst>
          </p:cNvPr>
          <p:cNvSpPr txBox="1"/>
          <p:nvPr/>
        </p:nvSpPr>
        <p:spPr>
          <a:xfrm>
            <a:off x="11720772" y="16702979"/>
            <a:ext cx="2098888" cy="584775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r" fontAlgn="b"/>
            <a:r>
              <a:rPr lang="en-US" altLang="zh-CN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L-1ra</a:t>
            </a:r>
            <a:endParaRPr lang="en-US" altLang="zh-CN" sz="3200" dirty="0">
              <a:solidFill>
                <a:srgbClr val="000000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34" name="Straight Connector 4">
            <a:extLst>
              <a:ext uri="{FF2B5EF4-FFF2-40B4-BE49-F238E27FC236}">
                <a16:creationId xmlns:a16="http://schemas.microsoft.com/office/drawing/2014/main" id="{C065BCBA-4DD0-AEAE-57B3-2C6C063B29E8}"/>
              </a:ext>
            </a:extLst>
          </p:cNvPr>
          <p:cNvCxnSpPr>
            <a:cxnSpLocks/>
          </p:cNvCxnSpPr>
          <p:nvPr/>
        </p:nvCxnSpPr>
        <p:spPr>
          <a:xfrm>
            <a:off x="12945746" y="9453619"/>
            <a:ext cx="2873372" cy="0"/>
          </a:xfrm>
          <a:prstGeom prst="line">
            <a:avLst/>
          </a:prstGeom>
          <a:ln w="381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5" name="TextBox 10">
            <a:extLst>
              <a:ext uri="{FF2B5EF4-FFF2-40B4-BE49-F238E27FC236}">
                <a16:creationId xmlns:a16="http://schemas.microsoft.com/office/drawing/2014/main" id="{737F8172-3C4C-BF4F-3C5E-1DF126746763}"/>
              </a:ext>
            </a:extLst>
          </p:cNvPr>
          <p:cNvSpPr txBox="1"/>
          <p:nvPr/>
        </p:nvSpPr>
        <p:spPr>
          <a:xfrm>
            <a:off x="12933810" y="8872671"/>
            <a:ext cx="287337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*</a:t>
            </a:r>
          </a:p>
        </p:txBody>
      </p:sp>
      <p:cxnSp>
        <p:nvCxnSpPr>
          <p:cNvPr id="36" name="Straight Connector 43">
            <a:extLst>
              <a:ext uri="{FF2B5EF4-FFF2-40B4-BE49-F238E27FC236}">
                <a16:creationId xmlns:a16="http://schemas.microsoft.com/office/drawing/2014/main" id="{49060738-C089-E723-0482-FC8B8DC36A2F}"/>
              </a:ext>
            </a:extLst>
          </p:cNvPr>
          <p:cNvCxnSpPr>
            <a:cxnSpLocks/>
          </p:cNvCxnSpPr>
          <p:nvPr/>
        </p:nvCxnSpPr>
        <p:spPr>
          <a:xfrm>
            <a:off x="12965562" y="10063219"/>
            <a:ext cx="971548" cy="0"/>
          </a:xfrm>
          <a:prstGeom prst="line">
            <a:avLst/>
          </a:prstGeom>
          <a:ln w="381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7" name="Straight Connector 44">
            <a:extLst>
              <a:ext uri="{FF2B5EF4-FFF2-40B4-BE49-F238E27FC236}">
                <a16:creationId xmlns:a16="http://schemas.microsoft.com/office/drawing/2014/main" id="{DE7799BD-DCE6-FEF6-4246-3ED914F22309}"/>
              </a:ext>
            </a:extLst>
          </p:cNvPr>
          <p:cNvCxnSpPr>
            <a:cxnSpLocks/>
          </p:cNvCxnSpPr>
          <p:nvPr/>
        </p:nvCxnSpPr>
        <p:spPr>
          <a:xfrm>
            <a:off x="16156438" y="10063219"/>
            <a:ext cx="971548" cy="0"/>
          </a:xfrm>
          <a:prstGeom prst="line">
            <a:avLst/>
          </a:prstGeom>
          <a:ln w="381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8" name="TextBox 45">
            <a:extLst>
              <a:ext uri="{FF2B5EF4-FFF2-40B4-BE49-F238E27FC236}">
                <a16:creationId xmlns:a16="http://schemas.microsoft.com/office/drawing/2014/main" id="{AFC92126-927F-6A58-5DE1-90FA32972309}"/>
              </a:ext>
            </a:extLst>
          </p:cNvPr>
          <p:cNvSpPr txBox="1"/>
          <p:nvPr/>
        </p:nvSpPr>
        <p:spPr>
          <a:xfrm>
            <a:off x="12598710" y="9482273"/>
            <a:ext cx="168249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*</a:t>
            </a:r>
          </a:p>
        </p:txBody>
      </p:sp>
      <p:cxnSp>
        <p:nvCxnSpPr>
          <p:cNvPr id="39" name="Straight Connector 48">
            <a:extLst>
              <a:ext uri="{FF2B5EF4-FFF2-40B4-BE49-F238E27FC236}">
                <a16:creationId xmlns:a16="http://schemas.microsoft.com/office/drawing/2014/main" id="{596BDAAF-AD06-AE03-35D4-6639A23F11FA}"/>
              </a:ext>
            </a:extLst>
          </p:cNvPr>
          <p:cNvCxnSpPr>
            <a:cxnSpLocks/>
          </p:cNvCxnSpPr>
          <p:nvPr/>
        </p:nvCxnSpPr>
        <p:spPr>
          <a:xfrm>
            <a:off x="14255688" y="8844099"/>
            <a:ext cx="2852480" cy="0"/>
          </a:xfrm>
          <a:prstGeom prst="line">
            <a:avLst/>
          </a:prstGeom>
          <a:ln w="381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0" name="TextBox 49">
            <a:extLst>
              <a:ext uri="{FF2B5EF4-FFF2-40B4-BE49-F238E27FC236}">
                <a16:creationId xmlns:a16="http://schemas.microsoft.com/office/drawing/2014/main" id="{E5DC050C-C1DE-BC91-D7B1-59C8791ECAA4}"/>
              </a:ext>
            </a:extLst>
          </p:cNvPr>
          <p:cNvSpPr txBox="1"/>
          <p:nvPr/>
        </p:nvSpPr>
        <p:spPr>
          <a:xfrm>
            <a:off x="14255692" y="8263153"/>
            <a:ext cx="285248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</a:p>
        </p:txBody>
      </p:sp>
      <p:cxnSp>
        <p:nvCxnSpPr>
          <p:cNvPr id="41" name="Straight Connector 63">
            <a:extLst>
              <a:ext uri="{FF2B5EF4-FFF2-40B4-BE49-F238E27FC236}">
                <a16:creationId xmlns:a16="http://schemas.microsoft.com/office/drawing/2014/main" id="{3216B0C2-C6AC-A0A0-3D6D-D8773649543F}"/>
              </a:ext>
            </a:extLst>
          </p:cNvPr>
          <p:cNvCxnSpPr>
            <a:cxnSpLocks/>
          </p:cNvCxnSpPr>
          <p:nvPr/>
        </p:nvCxnSpPr>
        <p:spPr>
          <a:xfrm>
            <a:off x="5823434" y="10061243"/>
            <a:ext cx="2873372" cy="0"/>
          </a:xfrm>
          <a:prstGeom prst="line">
            <a:avLst/>
          </a:prstGeom>
          <a:ln w="381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2" name="TextBox 64">
            <a:extLst>
              <a:ext uri="{FF2B5EF4-FFF2-40B4-BE49-F238E27FC236}">
                <a16:creationId xmlns:a16="http://schemas.microsoft.com/office/drawing/2014/main" id="{904DDDD9-1D5C-D378-9712-85140EA11A46}"/>
              </a:ext>
            </a:extLst>
          </p:cNvPr>
          <p:cNvSpPr txBox="1"/>
          <p:nvPr/>
        </p:nvSpPr>
        <p:spPr>
          <a:xfrm>
            <a:off x="5811498" y="9480295"/>
            <a:ext cx="287337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*</a:t>
            </a:r>
          </a:p>
        </p:txBody>
      </p:sp>
      <p:cxnSp>
        <p:nvCxnSpPr>
          <p:cNvPr id="43" name="Straight Connector 66">
            <a:extLst>
              <a:ext uri="{FF2B5EF4-FFF2-40B4-BE49-F238E27FC236}">
                <a16:creationId xmlns:a16="http://schemas.microsoft.com/office/drawing/2014/main" id="{B7DA40B9-A033-BA36-863D-103552CC3DD8}"/>
              </a:ext>
            </a:extLst>
          </p:cNvPr>
          <p:cNvCxnSpPr>
            <a:cxnSpLocks/>
          </p:cNvCxnSpPr>
          <p:nvPr/>
        </p:nvCxnSpPr>
        <p:spPr>
          <a:xfrm>
            <a:off x="9034126" y="10063219"/>
            <a:ext cx="971548" cy="0"/>
          </a:xfrm>
          <a:prstGeom prst="line">
            <a:avLst/>
          </a:prstGeom>
          <a:ln w="381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4" name="TextBox 68">
            <a:extLst>
              <a:ext uri="{FF2B5EF4-FFF2-40B4-BE49-F238E27FC236}">
                <a16:creationId xmlns:a16="http://schemas.microsoft.com/office/drawing/2014/main" id="{6D1B7042-0A8C-C36C-CEDD-3293459E47DB}"/>
              </a:ext>
            </a:extLst>
          </p:cNvPr>
          <p:cNvSpPr txBox="1"/>
          <p:nvPr/>
        </p:nvSpPr>
        <p:spPr>
          <a:xfrm>
            <a:off x="8713046" y="9482273"/>
            <a:ext cx="168832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*</a:t>
            </a:r>
          </a:p>
        </p:txBody>
      </p:sp>
      <p:cxnSp>
        <p:nvCxnSpPr>
          <p:cNvPr id="45" name="Straight Connector 69">
            <a:extLst>
              <a:ext uri="{FF2B5EF4-FFF2-40B4-BE49-F238E27FC236}">
                <a16:creationId xmlns:a16="http://schemas.microsoft.com/office/drawing/2014/main" id="{4BF96F8E-8CB2-465C-4E82-82A5967CC3AB}"/>
              </a:ext>
            </a:extLst>
          </p:cNvPr>
          <p:cNvCxnSpPr>
            <a:cxnSpLocks/>
          </p:cNvCxnSpPr>
          <p:nvPr/>
        </p:nvCxnSpPr>
        <p:spPr>
          <a:xfrm>
            <a:off x="7133376" y="9451723"/>
            <a:ext cx="2852480" cy="0"/>
          </a:xfrm>
          <a:prstGeom prst="line">
            <a:avLst/>
          </a:prstGeom>
          <a:ln w="381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6" name="TextBox 70">
            <a:extLst>
              <a:ext uri="{FF2B5EF4-FFF2-40B4-BE49-F238E27FC236}">
                <a16:creationId xmlns:a16="http://schemas.microsoft.com/office/drawing/2014/main" id="{354BBB5C-521B-2883-7847-383045C0D022}"/>
              </a:ext>
            </a:extLst>
          </p:cNvPr>
          <p:cNvSpPr txBox="1"/>
          <p:nvPr/>
        </p:nvSpPr>
        <p:spPr>
          <a:xfrm>
            <a:off x="7133380" y="8870777"/>
            <a:ext cx="285248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</a:p>
        </p:txBody>
      </p:sp>
      <p:sp>
        <p:nvSpPr>
          <p:cNvPr id="47" name="TextBox 79">
            <a:extLst>
              <a:ext uri="{FF2B5EF4-FFF2-40B4-BE49-F238E27FC236}">
                <a16:creationId xmlns:a16="http://schemas.microsoft.com/office/drawing/2014/main" id="{741AFF8C-87EF-53D8-7D5B-CF47D60C257B}"/>
              </a:ext>
            </a:extLst>
          </p:cNvPr>
          <p:cNvSpPr txBox="1"/>
          <p:nvPr/>
        </p:nvSpPr>
        <p:spPr>
          <a:xfrm>
            <a:off x="15780418" y="9482273"/>
            <a:ext cx="168249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*</a:t>
            </a:r>
          </a:p>
        </p:txBody>
      </p:sp>
      <p:cxnSp>
        <p:nvCxnSpPr>
          <p:cNvPr id="48" name="Straight Connector 80">
            <a:extLst>
              <a:ext uri="{FF2B5EF4-FFF2-40B4-BE49-F238E27FC236}">
                <a16:creationId xmlns:a16="http://schemas.microsoft.com/office/drawing/2014/main" id="{1B5CF6D8-6424-608A-9EF0-DEDEAD09F2CC}"/>
              </a:ext>
            </a:extLst>
          </p:cNvPr>
          <p:cNvCxnSpPr>
            <a:cxnSpLocks/>
          </p:cNvCxnSpPr>
          <p:nvPr/>
        </p:nvCxnSpPr>
        <p:spPr>
          <a:xfrm>
            <a:off x="20576998" y="9453619"/>
            <a:ext cx="2873372" cy="0"/>
          </a:xfrm>
          <a:prstGeom prst="line">
            <a:avLst/>
          </a:prstGeom>
          <a:ln w="381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9" name="TextBox 81">
            <a:extLst>
              <a:ext uri="{FF2B5EF4-FFF2-40B4-BE49-F238E27FC236}">
                <a16:creationId xmlns:a16="http://schemas.microsoft.com/office/drawing/2014/main" id="{4CCCE069-49DB-5E79-2C61-37067389F50A}"/>
              </a:ext>
            </a:extLst>
          </p:cNvPr>
          <p:cNvSpPr txBox="1"/>
          <p:nvPr/>
        </p:nvSpPr>
        <p:spPr>
          <a:xfrm>
            <a:off x="20565062" y="8872671"/>
            <a:ext cx="287337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*</a:t>
            </a:r>
          </a:p>
        </p:txBody>
      </p:sp>
      <p:cxnSp>
        <p:nvCxnSpPr>
          <p:cNvPr id="50" name="Straight Connector 82">
            <a:extLst>
              <a:ext uri="{FF2B5EF4-FFF2-40B4-BE49-F238E27FC236}">
                <a16:creationId xmlns:a16="http://schemas.microsoft.com/office/drawing/2014/main" id="{524780CF-E45E-EF31-B647-55368FD937E7}"/>
              </a:ext>
            </a:extLst>
          </p:cNvPr>
          <p:cNvCxnSpPr>
            <a:cxnSpLocks/>
          </p:cNvCxnSpPr>
          <p:nvPr/>
        </p:nvCxnSpPr>
        <p:spPr>
          <a:xfrm>
            <a:off x="20596814" y="10063219"/>
            <a:ext cx="971548" cy="0"/>
          </a:xfrm>
          <a:prstGeom prst="line">
            <a:avLst/>
          </a:prstGeom>
          <a:ln w="381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1" name="Straight Connector 83">
            <a:extLst>
              <a:ext uri="{FF2B5EF4-FFF2-40B4-BE49-F238E27FC236}">
                <a16:creationId xmlns:a16="http://schemas.microsoft.com/office/drawing/2014/main" id="{2DB51655-1CA6-8FFF-958E-E072D62C7D96}"/>
              </a:ext>
            </a:extLst>
          </p:cNvPr>
          <p:cNvCxnSpPr>
            <a:cxnSpLocks/>
          </p:cNvCxnSpPr>
          <p:nvPr/>
        </p:nvCxnSpPr>
        <p:spPr>
          <a:xfrm>
            <a:off x="23787690" y="10063219"/>
            <a:ext cx="971548" cy="0"/>
          </a:xfrm>
          <a:prstGeom prst="line">
            <a:avLst/>
          </a:prstGeom>
          <a:ln w="381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2" name="TextBox 84">
            <a:extLst>
              <a:ext uri="{FF2B5EF4-FFF2-40B4-BE49-F238E27FC236}">
                <a16:creationId xmlns:a16="http://schemas.microsoft.com/office/drawing/2014/main" id="{3F214C1F-4186-CEA1-AF36-41F2B63A38F3}"/>
              </a:ext>
            </a:extLst>
          </p:cNvPr>
          <p:cNvSpPr txBox="1"/>
          <p:nvPr/>
        </p:nvSpPr>
        <p:spPr>
          <a:xfrm>
            <a:off x="20229962" y="9482271"/>
            <a:ext cx="168249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cxnSp>
        <p:nvCxnSpPr>
          <p:cNvPr id="53" name="Straight Connector 85">
            <a:extLst>
              <a:ext uri="{FF2B5EF4-FFF2-40B4-BE49-F238E27FC236}">
                <a16:creationId xmlns:a16="http://schemas.microsoft.com/office/drawing/2014/main" id="{85E3AE49-6F90-BDF3-67EA-BEEA1471C6B6}"/>
              </a:ext>
            </a:extLst>
          </p:cNvPr>
          <p:cNvCxnSpPr>
            <a:cxnSpLocks/>
          </p:cNvCxnSpPr>
          <p:nvPr/>
        </p:nvCxnSpPr>
        <p:spPr>
          <a:xfrm>
            <a:off x="21886940" y="8844099"/>
            <a:ext cx="2852480" cy="0"/>
          </a:xfrm>
          <a:prstGeom prst="line">
            <a:avLst/>
          </a:prstGeom>
          <a:ln w="381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4" name="TextBox 86">
            <a:extLst>
              <a:ext uri="{FF2B5EF4-FFF2-40B4-BE49-F238E27FC236}">
                <a16:creationId xmlns:a16="http://schemas.microsoft.com/office/drawing/2014/main" id="{3038A32B-0AB4-CE21-A2C2-1BEF0A1CF2BE}"/>
              </a:ext>
            </a:extLst>
          </p:cNvPr>
          <p:cNvSpPr txBox="1"/>
          <p:nvPr/>
        </p:nvSpPr>
        <p:spPr>
          <a:xfrm>
            <a:off x="21886944" y="8263151"/>
            <a:ext cx="285248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sp>
        <p:nvSpPr>
          <p:cNvPr id="55" name="TextBox 87">
            <a:extLst>
              <a:ext uri="{FF2B5EF4-FFF2-40B4-BE49-F238E27FC236}">
                <a16:creationId xmlns:a16="http://schemas.microsoft.com/office/drawing/2014/main" id="{89F04140-3CF5-CAAF-4731-BBB29D79E570}"/>
              </a:ext>
            </a:extLst>
          </p:cNvPr>
          <p:cNvSpPr txBox="1"/>
          <p:nvPr/>
        </p:nvSpPr>
        <p:spPr>
          <a:xfrm>
            <a:off x="23411670" y="9482273"/>
            <a:ext cx="168249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*</a:t>
            </a:r>
          </a:p>
        </p:txBody>
      </p:sp>
      <p:grpSp>
        <p:nvGrpSpPr>
          <p:cNvPr id="56" name="Group 27">
            <a:extLst>
              <a:ext uri="{FF2B5EF4-FFF2-40B4-BE49-F238E27FC236}">
                <a16:creationId xmlns:a16="http://schemas.microsoft.com/office/drawing/2014/main" id="{64ED2DB9-03E0-4BB0-AE12-B7C0C914162F}"/>
              </a:ext>
            </a:extLst>
          </p:cNvPr>
          <p:cNvGrpSpPr/>
          <p:nvPr/>
        </p:nvGrpSpPr>
        <p:grpSpPr>
          <a:xfrm>
            <a:off x="10187410" y="15328395"/>
            <a:ext cx="8928876" cy="746588"/>
            <a:chOff x="4331209" y="6023539"/>
            <a:chExt cx="2232219" cy="186647"/>
          </a:xfrm>
        </p:grpSpPr>
        <p:sp>
          <p:nvSpPr>
            <p:cNvPr id="57" name="Rectangle 11">
              <a:extLst>
                <a:ext uri="{FF2B5EF4-FFF2-40B4-BE49-F238E27FC236}">
                  <a16:creationId xmlns:a16="http://schemas.microsoft.com/office/drawing/2014/main" id="{C1372BD6-CA23-4713-A5C7-9A9BE564F58C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331209" y="6076717"/>
              <a:ext cx="122675" cy="122674"/>
            </a:xfrm>
            <a:prstGeom prst="rect">
              <a:avLst/>
            </a:prstGeom>
            <a:solidFill>
              <a:srgbClr val="C0FFFF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 sz="4000" dirty="0"/>
            </a:p>
          </p:txBody>
        </p:sp>
        <p:sp>
          <p:nvSpPr>
            <p:cNvPr id="58" name="Rectangle 12">
              <a:extLst>
                <a:ext uri="{FF2B5EF4-FFF2-40B4-BE49-F238E27FC236}">
                  <a16:creationId xmlns:a16="http://schemas.microsoft.com/office/drawing/2014/main" id="{D6628B17-A8D3-4378-8B48-F4CB8782EC85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594885" y="6062333"/>
              <a:ext cx="122675" cy="122674"/>
            </a:xfrm>
            <a:prstGeom prst="rect">
              <a:avLst/>
            </a:prstGeom>
            <a:solidFill>
              <a:srgbClr val="FFEFE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 sz="4000" dirty="0"/>
            </a:p>
          </p:txBody>
        </p:sp>
        <p:sp>
          <p:nvSpPr>
            <p:cNvPr id="59" name="TextBox 14">
              <a:extLst>
                <a:ext uri="{FF2B5EF4-FFF2-40B4-BE49-F238E27FC236}">
                  <a16:creationId xmlns:a16="http://schemas.microsoft.com/office/drawing/2014/main" id="{AD5459C5-317F-41AC-9857-46DC1925B9CF}"/>
                </a:ext>
              </a:extLst>
            </p:cNvPr>
            <p:cNvSpPr txBox="1"/>
            <p:nvPr/>
          </p:nvSpPr>
          <p:spPr>
            <a:xfrm>
              <a:off x="4458896" y="6033214"/>
              <a:ext cx="776735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4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-week MSCs</a:t>
              </a:r>
              <a:endParaRPr lang="en-JP" sz="4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TextBox 58">
              <a:extLst>
                <a:ext uri="{FF2B5EF4-FFF2-40B4-BE49-F238E27FC236}">
                  <a16:creationId xmlns:a16="http://schemas.microsoft.com/office/drawing/2014/main" id="{7DAD4511-DA90-4F79-8C47-0AE1C42939FB}"/>
                </a:ext>
              </a:extLst>
            </p:cNvPr>
            <p:cNvSpPr txBox="1"/>
            <p:nvPr/>
          </p:nvSpPr>
          <p:spPr>
            <a:xfrm>
              <a:off x="5722573" y="6023539"/>
              <a:ext cx="840855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4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-week MSCs</a:t>
              </a:r>
              <a:endParaRPr lang="en-JP" sz="4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aphicFrame>
        <p:nvGraphicFramePr>
          <p:cNvPr id="62" name="Table 61">
            <a:extLst>
              <a:ext uri="{FF2B5EF4-FFF2-40B4-BE49-F238E27FC236}">
                <a16:creationId xmlns:a16="http://schemas.microsoft.com/office/drawing/2014/main" id="{106FB12B-688A-4244-BC9B-8A7C64253F6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25043849"/>
              </p:ext>
            </p:extLst>
          </p:nvPr>
        </p:nvGraphicFramePr>
        <p:xfrm>
          <a:off x="2757867" y="219059"/>
          <a:ext cx="22805370" cy="706134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4326909">
                  <a:extLst>
                    <a:ext uri="{9D8B030D-6E8A-4147-A177-3AD203B41FA5}">
                      <a16:colId xmlns:a16="http://schemas.microsoft.com/office/drawing/2014/main" val="2362944156"/>
                    </a:ext>
                  </a:extLst>
                </a:gridCol>
                <a:gridCol w="4204989">
                  <a:extLst>
                    <a:ext uri="{9D8B030D-6E8A-4147-A177-3AD203B41FA5}">
                      <a16:colId xmlns:a16="http://schemas.microsoft.com/office/drawing/2014/main" val="2046327993"/>
                    </a:ext>
                  </a:extLst>
                </a:gridCol>
                <a:gridCol w="3290875">
                  <a:extLst>
                    <a:ext uri="{9D8B030D-6E8A-4147-A177-3AD203B41FA5}">
                      <a16:colId xmlns:a16="http://schemas.microsoft.com/office/drawing/2014/main" val="867884037"/>
                    </a:ext>
                  </a:extLst>
                </a:gridCol>
                <a:gridCol w="1862170">
                  <a:extLst>
                    <a:ext uri="{9D8B030D-6E8A-4147-A177-3AD203B41FA5}">
                      <a16:colId xmlns:a16="http://schemas.microsoft.com/office/drawing/2014/main" val="2882707498"/>
                    </a:ext>
                  </a:extLst>
                </a:gridCol>
                <a:gridCol w="2652181">
                  <a:extLst>
                    <a:ext uri="{9D8B030D-6E8A-4147-A177-3AD203B41FA5}">
                      <a16:colId xmlns:a16="http://schemas.microsoft.com/office/drawing/2014/main" val="2369536273"/>
                    </a:ext>
                  </a:extLst>
                </a:gridCol>
                <a:gridCol w="4034703">
                  <a:extLst>
                    <a:ext uri="{9D8B030D-6E8A-4147-A177-3AD203B41FA5}">
                      <a16:colId xmlns:a16="http://schemas.microsoft.com/office/drawing/2014/main" val="835850434"/>
                    </a:ext>
                  </a:extLst>
                </a:gridCol>
                <a:gridCol w="2433543">
                  <a:extLst>
                    <a:ext uri="{9D8B030D-6E8A-4147-A177-3AD203B41FA5}">
                      <a16:colId xmlns:a16="http://schemas.microsoft.com/office/drawing/2014/main" val="1663211205"/>
                    </a:ext>
                  </a:extLst>
                </a:gridCol>
              </a:tblGrid>
              <a:tr h="578030"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en-US" sz="4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3200" b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OVA table</a:t>
                      </a:r>
                      <a:endParaRPr lang="en-US" sz="3200" b="1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200" b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</a:t>
                      </a:r>
                      <a:endParaRPr lang="en-US" sz="3200" b="1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200" b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endParaRPr lang="en-US" sz="3200" b="1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200" b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S</a:t>
                      </a:r>
                      <a:endParaRPr lang="en-US" sz="3200" b="1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200" b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 (</a:t>
                      </a:r>
                      <a:r>
                        <a:rPr lang="en-US" sz="3200" b="1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Fn</a:t>
                      </a:r>
                      <a:r>
                        <a:rPr lang="en-US" sz="3200" b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US" sz="3200" b="1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Fd</a:t>
                      </a:r>
                      <a:r>
                        <a:rPr lang="en-US" sz="3200" b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3200" b="1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200" b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en-US" altLang="zh-CN" sz="3200" b="1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18543849"/>
                  </a:ext>
                </a:extLst>
              </a:tr>
              <a:tr h="669027">
                <a:tc rowSpan="3"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200" b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lative expressing level of </a:t>
                      </a:r>
                      <a:r>
                        <a:rPr lang="en-US" altLang="zh-CN" sz="3200" b="1" i="1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f</a:t>
                      </a:r>
                      <a:r>
                        <a:rPr lang="en-US" altLang="zh-CN" sz="3200" b="1" i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β</a:t>
                      </a:r>
                      <a:r>
                        <a:rPr lang="en-US" altLang="zh-CN" sz="3200" b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normalized by </a:t>
                      </a:r>
                      <a:r>
                        <a:rPr lang="en-US" altLang="zh-CN" sz="3200" b="1" i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29</a:t>
                      </a:r>
                      <a:endParaRPr lang="en-US" altLang="zh-CN" sz="3200" b="1" i="1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51460" marR="251460" marT="125730" marB="12573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28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ith/without M1  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238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238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 (1, 8) = 179.0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28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kumimoji="0" lang="en-US" sz="2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811933949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28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oung/aged </a:t>
                      </a: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SCs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32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32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28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 (1, 8) = 76.23</a:t>
                      </a:r>
                      <a:endParaRPr kumimoji="0" lang="en-US" sz="2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28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kumimoji="0" lang="en-US" sz="2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290200619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action</a:t>
                      </a:r>
                      <a:endParaRPr lang="en-US" altLang="zh-CN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47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47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28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 (1, 8) = 46.02</a:t>
                      </a:r>
                      <a:endParaRPr kumimoji="0" lang="en-US" sz="2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28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</a:t>
                      </a:r>
                      <a:endParaRPr kumimoji="0" lang="en-US" sz="2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46311931"/>
                  </a:ext>
                </a:extLst>
              </a:tr>
              <a:tr h="669027">
                <a:tc rowSpan="3"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3200" b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lative expressing level of </a:t>
                      </a:r>
                      <a:r>
                        <a:rPr kumimoji="0" lang="en-US" altLang="zh-CN" sz="3200" b="1" i="1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gf</a:t>
                      </a:r>
                      <a:r>
                        <a:rPr kumimoji="0" lang="en-US" altLang="zh-CN" sz="3200" b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normalized by </a:t>
                      </a:r>
                      <a:r>
                        <a:rPr kumimoji="0" lang="en-US" altLang="zh-CN" sz="3200" b="1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29</a:t>
                      </a:r>
                      <a:endParaRPr kumimoji="0" lang="en-US" altLang="zh-CN" sz="3200" b="1" i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51460" marR="251460" marT="125730" marB="12573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28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ith/without M1</a:t>
                      </a:r>
                      <a:endParaRPr lang="en-US" altLang="ja-JP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597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597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28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 (1, 8) = 115.2</a:t>
                      </a:r>
                      <a:endParaRPr kumimoji="0" lang="en-US" sz="2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2800" b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kumimoji="0" lang="en-US" sz="2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228628158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28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oung/aged </a:t>
                      </a:r>
                      <a:r>
                        <a:rPr lang="en-US" altLang="ja-JP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SCs</a:t>
                      </a:r>
                      <a:endParaRPr lang="en-US" altLang="ja-JP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80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80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28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 (1, 8) = 328.3</a:t>
                      </a:r>
                      <a:endParaRPr kumimoji="0" lang="en-US" sz="2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28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kumimoji="0" lang="en-US" sz="2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154818365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action</a:t>
                      </a:r>
                      <a:endParaRPr lang="en-US" altLang="zh-CN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024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024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28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 (1, 8) = 5.282</a:t>
                      </a:r>
                      <a:endParaRPr kumimoji="0" lang="en-US" sz="2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06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2597464"/>
                  </a:ext>
                </a:extLst>
              </a:tr>
              <a:tr h="669027">
                <a:tc rowSpan="3"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3200" b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lative expressing level of </a:t>
                      </a:r>
                      <a:r>
                        <a:rPr kumimoji="0" lang="en-US" altLang="zh-CN" sz="3200" b="1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2</a:t>
                      </a:r>
                      <a:r>
                        <a:rPr kumimoji="0" lang="en-US" altLang="zh-CN" sz="3200" b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normalized by </a:t>
                      </a:r>
                      <a:r>
                        <a:rPr kumimoji="0" lang="en-US" altLang="zh-CN" sz="3200" b="1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29</a:t>
                      </a:r>
                      <a:endParaRPr kumimoji="0" lang="en-US" altLang="zh-CN" sz="3200" b="1" i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51460" marR="251460" marT="125730" marB="12573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28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ith/without M1</a:t>
                      </a:r>
                      <a:endParaRPr lang="en-US" altLang="ja-JP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04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04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28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 (1, 8) = 741.9</a:t>
                      </a:r>
                      <a:endParaRPr kumimoji="0" lang="en-US" sz="2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011295905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28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oung/aged </a:t>
                      </a:r>
                      <a:r>
                        <a:rPr lang="en-US" altLang="ja-JP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SCs</a:t>
                      </a:r>
                      <a:endParaRPr lang="en-US" altLang="ja-JP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53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53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28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 (1, 8) = 715.0</a:t>
                      </a:r>
                      <a:endParaRPr kumimoji="0" lang="en-US" sz="2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226531076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action</a:t>
                      </a:r>
                      <a:endParaRPr lang="en-US" altLang="zh-CN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174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174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28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 (1, 8) = 273.3</a:t>
                      </a:r>
                      <a:endParaRPr kumimoji="0" lang="en-US" sz="2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7955646"/>
                  </a:ext>
                </a:extLst>
              </a:tr>
              <a:tr h="0">
                <a:tc gridSpan="7">
                  <a:txBody>
                    <a:bodyPr/>
                    <a:lstStyle/>
                    <a:p>
                      <a:pPr marL="0" marR="0" lvl="0" indent="0" algn="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: Sum-of-squares    DF: Degrees of freedom    MS: Mean squares</a:t>
                      </a:r>
                      <a:endParaRPr lang="en-US" altLang="zh-CN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51460" marR="251460" marT="125730" marB="12573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51460" marR="251460" marT="125730" marB="12573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26194" marR="26194" marT="26194" marB="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/>
                </a:tc>
                <a:tc hMerge="1"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2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/>
                </a:tc>
                <a:tc hMerge="1"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/>
                </a:tc>
                <a:extLst>
                  <a:ext uri="{0D108BD9-81ED-4DB2-BD59-A6C34878D82A}">
                    <a16:rowId xmlns:a16="http://schemas.microsoft.com/office/drawing/2014/main" val="113680193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520405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D481A265-E0F7-CF1D-CAE2-068809776E35}"/>
              </a:ext>
            </a:extLst>
          </p:cNvPr>
          <p:cNvSpPr txBox="1"/>
          <p:nvPr/>
        </p:nvSpPr>
        <p:spPr>
          <a:xfrm>
            <a:off x="3812457" y="3549302"/>
            <a:ext cx="21259800" cy="693420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altLang="zh-CN" sz="36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en-US" altLang="zh-CN" sz="3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36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aged MSCs showed lower </a:t>
            </a:r>
            <a:r>
              <a:rPr lang="en-US" altLang="zh-CN" sz="36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ti-inflammatory </a:t>
            </a:r>
            <a:r>
              <a:rPr lang="en-US" altLang="zh-CN" sz="36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ytokine secretion </a:t>
            </a:r>
            <a:r>
              <a:rPr lang="en-US" altLang="zh-CN" sz="3600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 vitro</a:t>
            </a:r>
            <a:r>
              <a:rPr lang="en-US" altLang="zh-CN" sz="36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3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 Bone marrow-derived monocytes were stimulated with 100 ng/mL M-CSF for 6 hours and then induced with 100 ng/mL LPS and 50 ng/mL </a:t>
            </a:r>
            <a:r>
              <a:rPr lang="en-US" altLang="zh-CN" sz="36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FN-</a:t>
            </a:r>
            <a:r>
              <a:rPr lang="en-US" altLang="zh-CN" sz="3600" dirty="0" err="1">
                <a:solidFill>
                  <a:srgbClr val="000000"/>
                </a:solidFill>
                <a:effectLst/>
                <a:latin typeface="Symbol" pitchFamily="2" charset="2"/>
                <a:ea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US" altLang="zh-CN" sz="36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3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 M1 for 24 hours. The 5- or 50-week MSCs were added to the </a:t>
            </a:r>
            <a:r>
              <a:rPr lang="en-US" altLang="zh-CN" sz="36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answell</a:t>
            </a:r>
            <a:r>
              <a:rPr lang="en-US" altLang="zh-CN" sz="3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upper-chamber) at a 1:1 ratio with or without M1 for 24 hours, and the relative gene expression levels of anti-inflammatory cytokines (</a:t>
            </a:r>
            <a:r>
              <a:rPr lang="en-US" altLang="zh-CN" sz="3600" i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f</a:t>
            </a:r>
            <a:r>
              <a:rPr lang="en-US" altLang="zh-CN" sz="36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β, </a:t>
            </a:r>
            <a:r>
              <a:rPr lang="en-US" altLang="zh-CN" sz="3600" i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gf</a:t>
            </a:r>
            <a:r>
              <a:rPr lang="en-US" altLang="zh-CN" sz="36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3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altLang="zh-CN" sz="36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l-2</a:t>
            </a:r>
            <a:r>
              <a:rPr lang="en-US" altLang="zh-CN" sz="3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in young or aged MSCs were measured by real-time RT-PCR. (b) The supernatant from M0 only, M1 only, or M1 and MSCs co-culture were collected after 24 hours culturing and applied to protein microarrays. The density of the dots was quantified with ImageJ software. Data are presented as mean ± standard deviation of three independent experiments. Two-way factorial ANOVA was performed to confirm statistical significance for main effects of </a:t>
            </a:r>
            <a:r>
              <a:rPr lang="en-US" altLang="zh-CN" sz="36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wo</a:t>
            </a:r>
            <a:r>
              <a:rPr lang="en-US" altLang="zh-CN" sz="3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actors (</a:t>
            </a:r>
            <a:r>
              <a:rPr lang="en-US" altLang="zh-CN" sz="36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direct</a:t>
            </a:r>
            <a:r>
              <a:rPr lang="en-US" altLang="zh-CN" sz="3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-culture conditions [with and without M1] and MSCs types [young and aged]) and those interaction on the relative gene expression levels of anti-inflammatory cytokines (</a:t>
            </a:r>
            <a:r>
              <a:rPr lang="en-US" altLang="zh-CN" sz="3600" i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f</a:t>
            </a:r>
            <a:r>
              <a:rPr lang="en-US" altLang="zh-CN" sz="36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β, </a:t>
            </a:r>
            <a:r>
              <a:rPr lang="en-US" altLang="zh-CN" sz="3600" i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gf</a:t>
            </a:r>
            <a:r>
              <a:rPr lang="en-US" altLang="zh-CN" sz="36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3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altLang="zh-CN" sz="36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l-2</a:t>
            </a:r>
            <a:r>
              <a:rPr lang="en-US" altLang="zh-CN" sz="3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in young or aged MSCs. Then, Tukey’s post-hoc tests were proceeded to confirm the mean difference between the bars. (**** </a:t>
            </a:r>
            <a:r>
              <a:rPr lang="en-US" altLang="zh-CN" sz="36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3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&lt; 0.0001, *** </a:t>
            </a:r>
            <a:r>
              <a:rPr lang="en-US" altLang="zh-CN" sz="36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3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&lt; 0.001, **</a:t>
            </a:r>
            <a:r>
              <a:rPr lang="en-US" altLang="zh-CN" sz="36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</a:t>
            </a:r>
            <a:r>
              <a:rPr lang="en-US" altLang="zh-CN" sz="3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&lt; 0.01, n = 3).</a:t>
            </a:r>
            <a:endParaRPr lang="zh-CN" altLang="zh-CN" sz="36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60">
            <a:extLst>
              <a:ext uri="{FF2B5EF4-FFF2-40B4-BE49-F238E27FC236}">
                <a16:creationId xmlns:a16="http://schemas.microsoft.com/office/drawing/2014/main" id="{B5917006-3123-4C13-1294-66070DF51966}"/>
              </a:ext>
            </a:extLst>
          </p:cNvPr>
          <p:cNvSpPr txBox="1"/>
          <p:nvPr/>
        </p:nvSpPr>
        <p:spPr>
          <a:xfrm>
            <a:off x="23181968" y="38166451"/>
            <a:ext cx="378057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JP" sz="4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18849316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7">
            <a:extLst>
              <a:ext uri="{FF2B5EF4-FFF2-40B4-BE49-F238E27FC236}">
                <a16:creationId xmlns:a16="http://schemas.microsoft.com/office/drawing/2014/main" id="{945B4552-34C5-70E1-F660-8F773737CAC2}"/>
              </a:ext>
            </a:extLst>
          </p:cNvPr>
          <p:cNvGrpSpPr/>
          <p:nvPr/>
        </p:nvGrpSpPr>
        <p:grpSpPr>
          <a:xfrm>
            <a:off x="20143977" y="8277357"/>
            <a:ext cx="3874172" cy="1839292"/>
            <a:chOff x="4326196" y="6033214"/>
            <a:chExt cx="968543" cy="459823"/>
          </a:xfrm>
        </p:grpSpPr>
        <p:sp>
          <p:nvSpPr>
            <p:cNvPr id="4" name="Rectangle 11">
              <a:extLst>
                <a:ext uri="{FF2B5EF4-FFF2-40B4-BE49-F238E27FC236}">
                  <a16:creationId xmlns:a16="http://schemas.microsoft.com/office/drawing/2014/main" id="{5613CFAC-1D96-5426-213B-7EC35080A917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331209" y="6076717"/>
              <a:ext cx="122675" cy="122674"/>
            </a:xfrm>
            <a:prstGeom prst="rect">
              <a:avLst/>
            </a:prstGeom>
            <a:solidFill>
              <a:srgbClr val="C0FFFF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 sz="4000" dirty="0"/>
            </a:p>
          </p:txBody>
        </p:sp>
        <p:sp>
          <p:nvSpPr>
            <p:cNvPr id="5" name="Rectangle 12">
              <a:extLst>
                <a:ext uri="{FF2B5EF4-FFF2-40B4-BE49-F238E27FC236}">
                  <a16:creationId xmlns:a16="http://schemas.microsoft.com/office/drawing/2014/main" id="{4D254D3A-3289-2A6D-F012-DBFA0707DB83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326196" y="6354859"/>
              <a:ext cx="122675" cy="122674"/>
            </a:xfrm>
            <a:prstGeom prst="rect">
              <a:avLst/>
            </a:prstGeom>
            <a:solidFill>
              <a:srgbClr val="FFEFE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 sz="4000" dirty="0"/>
            </a:p>
          </p:txBody>
        </p:sp>
        <p:sp>
          <p:nvSpPr>
            <p:cNvPr id="6" name="TextBox 14">
              <a:extLst>
                <a:ext uri="{FF2B5EF4-FFF2-40B4-BE49-F238E27FC236}">
                  <a16:creationId xmlns:a16="http://schemas.microsoft.com/office/drawing/2014/main" id="{05689B2E-C2EE-F323-78CC-D5FE83D39625}"/>
                </a:ext>
              </a:extLst>
            </p:cNvPr>
            <p:cNvSpPr txBox="1"/>
            <p:nvPr/>
          </p:nvSpPr>
          <p:spPr>
            <a:xfrm>
              <a:off x="4458896" y="6033214"/>
              <a:ext cx="776735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4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-week MSCs</a:t>
              </a:r>
              <a:endParaRPr lang="en-JP" sz="4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58">
              <a:extLst>
                <a:ext uri="{FF2B5EF4-FFF2-40B4-BE49-F238E27FC236}">
                  <a16:creationId xmlns:a16="http://schemas.microsoft.com/office/drawing/2014/main" id="{0DA62DA4-3E20-C542-245D-A1515D89D918}"/>
                </a:ext>
              </a:extLst>
            </p:cNvPr>
            <p:cNvSpPr txBox="1"/>
            <p:nvPr/>
          </p:nvSpPr>
          <p:spPr>
            <a:xfrm>
              <a:off x="4453884" y="6316065"/>
              <a:ext cx="840855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4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-week MSCs</a:t>
              </a:r>
              <a:endParaRPr lang="en-JP" sz="4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aphicFrame>
        <p:nvGraphicFramePr>
          <p:cNvPr id="8" name="Object 32">
            <a:extLst>
              <a:ext uri="{FF2B5EF4-FFF2-40B4-BE49-F238E27FC236}">
                <a16:creationId xmlns:a16="http://schemas.microsoft.com/office/drawing/2014/main" id="{C16CE1F8-CFF8-ECA6-EA26-3D97452E9D6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09184924"/>
              </p:ext>
            </p:extLst>
          </p:nvPr>
        </p:nvGraphicFramePr>
        <p:xfrm>
          <a:off x="2873199" y="7411199"/>
          <a:ext cx="10287000" cy="86423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572089" imgH="2160564" progId="Prism9.Document">
                  <p:embed/>
                </p:oleObj>
              </mc:Choice>
              <mc:Fallback>
                <p:oleObj name="Prism 9" r:id="rId2" imgW="2572089" imgH="2160564" progId="Prism9.Document">
                  <p:embed/>
                  <p:pic>
                    <p:nvPicPr>
                      <p:cNvPr id="8" name="Object 32">
                        <a:extLst>
                          <a:ext uri="{FF2B5EF4-FFF2-40B4-BE49-F238E27FC236}">
                            <a16:creationId xmlns:a16="http://schemas.microsoft.com/office/drawing/2014/main" id="{4F24B731-A161-ECF8-2A48-737A23CC75B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873199" y="7411199"/>
                        <a:ext cx="10287000" cy="86423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9" name="Straight Connector 33">
            <a:extLst>
              <a:ext uri="{FF2B5EF4-FFF2-40B4-BE49-F238E27FC236}">
                <a16:creationId xmlns:a16="http://schemas.microsoft.com/office/drawing/2014/main" id="{5206BD07-1B10-CA75-AC97-C9D9339B51D8}"/>
              </a:ext>
            </a:extLst>
          </p:cNvPr>
          <p:cNvCxnSpPr>
            <a:cxnSpLocks/>
          </p:cNvCxnSpPr>
          <p:nvPr/>
        </p:nvCxnSpPr>
        <p:spPr>
          <a:xfrm>
            <a:off x="6597073" y="9630469"/>
            <a:ext cx="2873372" cy="0"/>
          </a:xfrm>
          <a:prstGeom prst="line">
            <a:avLst/>
          </a:prstGeom>
          <a:ln w="381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" name="TextBox 34">
            <a:extLst>
              <a:ext uri="{FF2B5EF4-FFF2-40B4-BE49-F238E27FC236}">
                <a16:creationId xmlns:a16="http://schemas.microsoft.com/office/drawing/2014/main" id="{713AB9F8-14CC-4897-0E9F-8E593B379607}"/>
              </a:ext>
            </a:extLst>
          </p:cNvPr>
          <p:cNvSpPr txBox="1"/>
          <p:nvPr/>
        </p:nvSpPr>
        <p:spPr>
          <a:xfrm>
            <a:off x="6585137" y="9049521"/>
            <a:ext cx="287337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*</a:t>
            </a:r>
          </a:p>
        </p:txBody>
      </p:sp>
      <p:cxnSp>
        <p:nvCxnSpPr>
          <p:cNvPr id="11" name="Straight Connector 35">
            <a:extLst>
              <a:ext uri="{FF2B5EF4-FFF2-40B4-BE49-F238E27FC236}">
                <a16:creationId xmlns:a16="http://schemas.microsoft.com/office/drawing/2014/main" id="{33230777-01F7-A989-C227-BBE06CB99C00}"/>
              </a:ext>
            </a:extLst>
          </p:cNvPr>
          <p:cNvCxnSpPr>
            <a:cxnSpLocks/>
          </p:cNvCxnSpPr>
          <p:nvPr/>
        </p:nvCxnSpPr>
        <p:spPr>
          <a:xfrm>
            <a:off x="9807765" y="9632445"/>
            <a:ext cx="971548" cy="0"/>
          </a:xfrm>
          <a:prstGeom prst="line">
            <a:avLst/>
          </a:prstGeom>
          <a:ln w="381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" name="TextBox 36">
            <a:extLst>
              <a:ext uri="{FF2B5EF4-FFF2-40B4-BE49-F238E27FC236}">
                <a16:creationId xmlns:a16="http://schemas.microsoft.com/office/drawing/2014/main" id="{B1AC6C46-AB85-A1E6-1722-A9EF46CB0B9A}"/>
              </a:ext>
            </a:extLst>
          </p:cNvPr>
          <p:cNvSpPr txBox="1"/>
          <p:nvPr/>
        </p:nvSpPr>
        <p:spPr>
          <a:xfrm>
            <a:off x="9486685" y="9051497"/>
            <a:ext cx="168832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cxnSp>
        <p:nvCxnSpPr>
          <p:cNvPr id="13" name="Straight Connector 37">
            <a:extLst>
              <a:ext uri="{FF2B5EF4-FFF2-40B4-BE49-F238E27FC236}">
                <a16:creationId xmlns:a16="http://schemas.microsoft.com/office/drawing/2014/main" id="{9E7E9866-8BBC-2BFF-CA7C-65510AD00492}"/>
              </a:ext>
            </a:extLst>
          </p:cNvPr>
          <p:cNvCxnSpPr>
            <a:cxnSpLocks/>
          </p:cNvCxnSpPr>
          <p:nvPr/>
        </p:nvCxnSpPr>
        <p:spPr>
          <a:xfrm>
            <a:off x="7907015" y="9020949"/>
            <a:ext cx="2852480" cy="0"/>
          </a:xfrm>
          <a:prstGeom prst="line">
            <a:avLst/>
          </a:prstGeom>
          <a:ln w="381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" name="TextBox 38">
            <a:extLst>
              <a:ext uri="{FF2B5EF4-FFF2-40B4-BE49-F238E27FC236}">
                <a16:creationId xmlns:a16="http://schemas.microsoft.com/office/drawing/2014/main" id="{D68A02E5-22B9-5A03-5EC6-4788D6FF4B2D}"/>
              </a:ext>
            </a:extLst>
          </p:cNvPr>
          <p:cNvSpPr txBox="1"/>
          <p:nvPr/>
        </p:nvSpPr>
        <p:spPr>
          <a:xfrm>
            <a:off x="7907019" y="8578548"/>
            <a:ext cx="285248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</a:p>
        </p:txBody>
      </p:sp>
      <p:graphicFrame>
        <p:nvGraphicFramePr>
          <p:cNvPr id="15" name="Object 39">
            <a:extLst>
              <a:ext uri="{FF2B5EF4-FFF2-40B4-BE49-F238E27FC236}">
                <a16:creationId xmlns:a16="http://schemas.microsoft.com/office/drawing/2014/main" id="{59F893E5-B3D5-E136-65C1-428E449C8C1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62702892"/>
              </p:ext>
            </p:extLst>
          </p:nvPr>
        </p:nvGraphicFramePr>
        <p:xfrm>
          <a:off x="12346172" y="7455647"/>
          <a:ext cx="8794752" cy="86042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2198268" imgH="2151200" progId="Prism9.Document">
                  <p:embed/>
                </p:oleObj>
              </mc:Choice>
              <mc:Fallback>
                <p:oleObj name="Prism 9" r:id="rId4" imgW="2198268" imgH="2151200" progId="Prism9.Document">
                  <p:embed/>
                  <p:pic>
                    <p:nvPicPr>
                      <p:cNvPr id="15" name="Object 39">
                        <a:extLst>
                          <a:ext uri="{FF2B5EF4-FFF2-40B4-BE49-F238E27FC236}">
                            <a16:creationId xmlns:a16="http://schemas.microsoft.com/office/drawing/2014/main" id="{6C43233B-AD8D-775C-399F-E7B9B73232B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2346172" y="7455647"/>
                        <a:ext cx="8794752" cy="86042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6" name="Straight Connector 40">
            <a:extLst>
              <a:ext uri="{FF2B5EF4-FFF2-40B4-BE49-F238E27FC236}">
                <a16:creationId xmlns:a16="http://schemas.microsoft.com/office/drawing/2014/main" id="{FD48E117-7A2D-8982-F0F2-FE1DE232C441}"/>
              </a:ext>
            </a:extLst>
          </p:cNvPr>
          <p:cNvCxnSpPr>
            <a:cxnSpLocks/>
          </p:cNvCxnSpPr>
          <p:nvPr/>
        </p:nvCxnSpPr>
        <p:spPr>
          <a:xfrm>
            <a:off x="14301876" y="9630469"/>
            <a:ext cx="2873372" cy="0"/>
          </a:xfrm>
          <a:prstGeom prst="line">
            <a:avLst/>
          </a:prstGeom>
          <a:ln w="381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TextBox 41">
            <a:extLst>
              <a:ext uri="{FF2B5EF4-FFF2-40B4-BE49-F238E27FC236}">
                <a16:creationId xmlns:a16="http://schemas.microsoft.com/office/drawing/2014/main" id="{28CC0071-D3EB-DBB5-2E15-3B0BE6E0AE02}"/>
              </a:ext>
            </a:extLst>
          </p:cNvPr>
          <p:cNvSpPr txBox="1"/>
          <p:nvPr/>
        </p:nvSpPr>
        <p:spPr>
          <a:xfrm>
            <a:off x="14289940" y="9049521"/>
            <a:ext cx="287337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*</a:t>
            </a:r>
          </a:p>
        </p:txBody>
      </p:sp>
      <p:cxnSp>
        <p:nvCxnSpPr>
          <p:cNvPr id="18" name="Straight Connector 42">
            <a:extLst>
              <a:ext uri="{FF2B5EF4-FFF2-40B4-BE49-F238E27FC236}">
                <a16:creationId xmlns:a16="http://schemas.microsoft.com/office/drawing/2014/main" id="{EB118F7B-D7BF-4CA6-4D9F-1ABD7983165C}"/>
              </a:ext>
            </a:extLst>
          </p:cNvPr>
          <p:cNvCxnSpPr>
            <a:cxnSpLocks/>
          </p:cNvCxnSpPr>
          <p:nvPr/>
        </p:nvCxnSpPr>
        <p:spPr>
          <a:xfrm>
            <a:off x="17512568" y="9632445"/>
            <a:ext cx="971548" cy="0"/>
          </a:xfrm>
          <a:prstGeom prst="line">
            <a:avLst/>
          </a:prstGeom>
          <a:ln w="381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9" name="TextBox 43">
            <a:extLst>
              <a:ext uri="{FF2B5EF4-FFF2-40B4-BE49-F238E27FC236}">
                <a16:creationId xmlns:a16="http://schemas.microsoft.com/office/drawing/2014/main" id="{BF12CAE0-8155-FB2C-214B-41D056A78BA9}"/>
              </a:ext>
            </a:extLst>
          </p:cNvPr>
          <p:cNvSpPr txBox="1"/>
          <p:nvPr/>
        </p:nvSpPr>
        <p:spPr>
          <a:xfrm>
            <a:off x="17191488" y="9051499"/>
            <a:ext cx="168832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*</a:t>
            </a:r>
          </a:p>
        </p:txBody>
      </p:sp>
      <p:cxnSp>
        <p:nvCxnSpPr>
          <p:cNvPr id="20" name="Straight Connector 44">
            <a:extLst>
              <a:ext uri="{FF2B5EF4-FFF2-40B4-BE49-F238E27FC236}">
                <a16:creationId xmlns:a16="http://schemas.microsoft.com/office/drawing/2014/main" id="{F641C5F7-861C-085C-EA9F-4C0E8853138D}"/>
              </a:ext>
            </a:extLst>
          </p:cNvPr>
          <p:cNvCxnSpPr>
            <a:cxnSpLocks/>
          </p:cNvCxnSpPr>
          <p:nvPr/>
        </p:nvCxnSpPr>
        <p:spPr>
          <a:xfrm>
            <a:off x="15611818" y="9020949"/>
            <a:ext cx="2852480" cy="0"/>
          </a:xfrm>
          <a:prstGeom prst="line">
            <a:avLst/>
          </a:prstGeom>
          <a:ln w="381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1" name="TextBox 45">
            <a:extLst>
              <a:ext uri="{FF2B5EF4-FFF2-40B4-BE49-F238E27FC236}">
                <a16:creationId xmlns:a16="http://schemas.microsoft.com/office/drawing/2014/main" id="{9C207AA7-B097-633F-F437-F7FBD4765BC3}"/>
              </a:ext>
            </a:extLst>
          </p:cNvPr>
          <p:cNvSpPr txBox="1"/>
          <p:nvPr/>
        </p:nvSpPr>
        <p:spPr>
          <a:xfrm>
            <a:off x="15611822" y="8578548"/>
            <a:ext cx="285248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E32ED83-9C9B-A091-AF90-62A2BCDB47CC}"/>
              </a:ext>
            </a:extLst>
          </p:cNvPr>
          <p:cNvSpPr txBox="1"/>
          <p:nvPr/>
        </p:nvSpPr>
        <p:spPr>
          <a:xfrm>
            <a:off x="23061267" y="37888493"/>
            <a:ext cx="378057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JP" sz="4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</a:p>
        </p:txBody>
      </p:sp>
      <p:graphicFrame>
        <p:nvGraphicFramePr>
          <p:cNvPr id="25" name="Table 24">
            <a:extLst>
              <a:ext uri="{FF2B5EF4-FFF2-40B4-BE49-F238E27FC236}">
                <a16:creationId xmlns:a16="http://schemas.microsoft.com/office/drawing/2014/main" id="{2C435583-4F8D-4ECA-8DD0-C710FCE0185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88273276"/>
              </p:ext>
            </p:extLst>
          </p:nvPr>
        </p:nvGraphicFramePr>
        <p:xfrm>
          <a:off x="2701024" y="1735507"/>
          <a:ext cx="22631719" cy="5331332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4153259">
                  <a:extLst>
                    <a:ext uri="{9D8B030D-6E8A-4147-A177-3AD203B41FA5}">
                      <a16:colId xmlns:a16="http://schemas.microsoft.com/office/drawing/2014/main" val="2362944156"/>
                    </a:ext>
                  </a:extLst>
                </a:gridCol>
                <a:gridCol w="4204989">
                  <a:extLst>
                    <a:ext uri="{9D8B030D-6E8A-4147-A177-3AD203B41FA5}">
                      <a16:colId xmlns:a16="http://schemas.microsoft.com/office/drawing/2014/main" val="2046327993"/>
                    </a:ext>
                  </a:extLst>
                </a:gridCol>
                <a:gridCol w="3290874">
                  <a:extLst>
                    <a:ext uri="{9D8B030D-6E8A-4147-A177-3AD203B41FA5}">
                      <a16:colId xmlns:a16="http://schemas.microsoft.com/office/drawing/2014/main" val="867884037"/>
                    </a:ext>
                  </a:extLst>
                </a:gridCol>
                <a:gridCol w="1862170">
                  <a:extLst>
                    <a:ext uri="{9D8B030D-6E8A-4147-A177-3AD203B41FA5}">
                      <a16:colId xmlns:a16="http://schemas.microsoft.com/office/drawing/2014/main" val="2882707498"/>
                    </a:ext>
                  </a:extLst>
                </a:gridCol>
                <a:gridCol w="2652181">
                  <a:extLst>
                    <a:ext uri="{9D8B030D-6E8A-4147-A177-3AD203B41FA5}">
                      <a16:colId xmlns:a16="http://schemas.microsoft.com/office/drawing/2014/main" val="2369536273"/>
                    </a:ext>
                  </a:extLst>
                </a:gridCol>
                <a:gridCol w="4034703">
                  <a:extLst>
                    <a:ext uri="{9D8B030D-6E8A-4147-A177-3AD203B41FA5}">
                      <a16:colId xmlns:a16="http://schemas.microsoft.com/office/drawing/2014/main" val="835850434"/>
                    </a:ext>
                  </a:extLst>
                </a:gridCol>
                <a:gridCol w="2433543">
                  <a:extLst>
                    <a:ext uri="{9D8B030D-6E8A-4147-A177-3AD203B41FA5}">
                      <a16:colId xmlns:a16="http://schemas.microsoft.com/office/drawing/2014/main" val="1663211205"/>
                    </a:ext>
                  </a:extLst>
                </a:gridCol>
              </a:tblGrid>
              <a:tr h="578030"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　</a:t>
                      </a:r>
                      <a:endParaRPr lang="en-US" sz="4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2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ANOVA table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2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SS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2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DF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2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MS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2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</a:t>
                      </a:r>
                      <a:r>
                        <a:rPr lang="en-US" sz="3200" b="1" i="0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DFn</a:t>
                      </a:r>
                      <a:r>
                        <a:rPr lang="en-US" sz="32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, </a:t>
                      </a:r>
                      <a:r>
                        <a:rPr lang="en-US" sz="3200" b="1" i="0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DFd</a:t>
                      </a:r>
                      <a:r>
                        <a:rPr lang="en-US" sz="32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)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200" b="1" i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P</a:t>
                      </a:r>
                      <a:r>
                        <a:rPr lang="en-US" altLang="zh-CN" sz="32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 value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18543849"/>
                  </a:ext>
                </a:extLst>
              </a:tr>
              <a:tr h="669027">
                <a:tc rowSpan="3"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3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Relative expressing level of </a:t>
                      </a:r>
                      <a:r>
                        <a:rPr kumimoji="0" lang="en-US" altLang="zh-CN" sz="3200" b="1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Il-4</a:t>
                      </a:r>
                      <a:r>
                        <a:rPr kumimoji="0" lang="en-US" altLang="zh-CN" sz="3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 normalized by </a:t>
                      </a:r>
                      <a:r>
                        <a:rPr kumimoji="0" lang="en-US" altLang="zh-CN" sz="3200" b="1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s29</a:t>
                      </a:r>
                    </a:p>
                  </a:txBody>
                  <a:tcPr marL="251460" marR="251460" marT="125730" marB="12573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28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ith/without M1</a:t>
                      </a:r>
                      <a:endParaRPr lang="en-US" altLang="ja-JP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.685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.685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1, 8) = 88.76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11933949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28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oung/aged </a:t>
                      </a:r>
                      <a:r>
                        <a:rPr lang="en-US" altLang="ja-JP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SCs</a:t>
                      </a:r>
                      <a:endParaRPr lang="en-US" altLang="ja-JP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.101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.101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1, 8) = 36.41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003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90200619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2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interaction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3084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3084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1, 8) = 10.20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127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46311931"/>
                  </a:ext>
                </a:extLst>
              </a:tr>
              <a:tr h="669027">
                <a:tc rowSpan="3"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3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Relative expressing level of </a:t>
                      </a:r>
                      <a:r>
                        <a:rPr kumimoji="0" lang="en-US" altLang="zh-CN" sz="3200" b="1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Il-13</a:t>
                      </a:r>
                      <a:r>
                        <a:rPr kumimoji="0" lang="en-US" altLang="zh-CN" sz="3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 normalized by </a:t>
                      </a:r>
                      <a:r>
                        <a:rPr kumimoji="0" lang="en-US" altLang="zh-CN" sz="3200" b="1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s29</a:t>
                      </a:r>
                    </a:p>
                  </a:txBody>
                  <a:tcPr marL="251460" marR="251460" marT="125730" marB="12573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28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ith/without M1</a:t>
                      </a:r>
                      <a:endParaRPr lang="en-US" altLang="ja-JP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30.25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30.25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1, 8) = 244.0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28628158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28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oung/aged </a:t>
                      </a:r>
                      <a:r>
                        <a:rPr lang="en-US" altLang="ja-JP" sz="28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SCs</a:t>
                      </a:r>
                      <a:endParaRPr lang="en-US" altLang="ja-JP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6.66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6.66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1, 8) = 134.4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54818365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endParaRPr lang="en-JP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2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interaction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6.577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6.577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1, 8) = 53.06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22597464"/>
                  </a:ext>
                </a:extLst>
              </a:tr>
              <a:tr h="669027">
                <a:tc gridSpan="7">
                  <a:txBody>
                    <a:bodyPr/>
                    <a:lstStyle/>
                    <a:p>
                      <a:pPr marL="0" marR="0" lvl="0" indent="0" algn="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2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: Sum-of-squares    DF: Degrees of freedom    MS: Mean </a:t>
                      </a:r>
                      <a:r>
                        <a:rPr lang="en-US" altLang="zh-CN" sz="32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quares    </a:t>
                      </a:r>
                      <a:r>
                        <a:rPr lang="en-US" altLang="zh-CN" sz="3200" b="0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Fn</a:t>
                      </a:r>
                      <a:r>
                        <a:rPr lang="en-US" altLang="zh-CN" sz="32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: DF in numerator    </a:t>
                      </a:r>
                      <a:r>
                        <a:rPr lang="en-US" altLang="zh-CN" sz="3200" b="0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Fd</a:t>
                      </a:r>
                      <a:r>
                        <a:rPr lang="en-US" altLang="zh-CN" sz="32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: DF in denominator</a:t>
                      </a:r>
                    </a:p>
                  </a:txBody>
                  <a:tcPr marL="251460" marR="251460" marT="125730" marB="12573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28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28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28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28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53986530"/>
                  </a:ext>
                </a:extLst>
              </a:tr>
            </a:tbl>
          </a:graphicData>
        </a:graphic>
      </p:graphicFrame>
      <p:sp>
        <p:nvSpPr>
          <p:cNvPr id="24" name="文本框 23">
            <a:extLst>
              <a:ext uri="{FF2B5EF4-FFF2-40B4-BE49-F238E27FC236}">
                <a16:creationId xmlns:a16="http://schemas.microsoft.com/office/drawing/2014/main" id="{8940C18F-2972-56E8-6C66-A5213BB5D008}"/>
              </a:ext>
            </a:extLst>
          </p:cNvPr>
          <p:cNvSpPr txBox="1"/>
          <p:nvPr/>
        </p:nvSpPr>
        <p:spPr>
          <a:xfrm>
            <a:off x="2533572" y="16406588"/>
            <a:ext cx="22966624" cy="43027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altLang="zh-CN" sz="36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.</a:t>
            </a:r>
            <a:r>
              <a:rPr lang="en-US" altLang="zh-CN" sz="3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36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ed MSCs showed lower expression of </a:t>
            </a:r>
            <a:r>
              <a:rPr lang="en-US" altLang="zh-CN" sz="3600" b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2</a:t>
            </a:r>
            <a:r>
              <a:rPr lang="en-US" altLang="zh-CN" sz="36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inducer genes. </a:t>
            </a:r>
            <a:r>
              <a:rPr lang="en-US" altLang="zh-CN" sz="3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5- or 50-week MSCs were added to the Transwell (upper-chamber) at a 1:1 ratio with or without M1 for 24 hours, and the relative gene expression levels of M2-inducers (</a:t>
            </a:r>
            <a:r>
              <a:rPr lang="en-US" altLang="zh-CN" sz="36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l-4 </a:t>
            </a:r>
            <a:r>
              <a:rPr lang="en-US" altLang="zh-CN" sz="3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altLang="zh-CN" sz="36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l-13</a:t>
            </a:r>
            <a:r>
              <a:rPr lang="en-US" altLang="zh-CN" sz="3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in young or aged MSCs were measured by real-time RT-PCR. Data are presented as mean ± standard deviation of three independent experiments. Two-way factorial ANOVA was performed to confirm statistical significance for main effects of both factors (</a:t>
            </a:r>
            <a:r>
              <a:rPr lang="en-US" altLang="zh-CN" sz="36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direct</a:t>
            </a:r>
            <a:r>
              <a:rPr lang="en-US" altLang="zh-CN" sz="3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-culture conditions [with and without M1] and MSCs types [young and aged]) and those interaction on the relative expression levels of M2-inducer genes (</a:t>
            </a:r>
            <a:r>
              <a:rPr lang="en-US" altLang="zh-CN" sz="36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l-4 </a:t>
            </a:r>
            <a:r>
              <a:rPr lang="en-US" altLang="zh-CN" sz="3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altLang="zh-CN" sz="36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l-13</a:t>
            </a:r>
            <a:r>
              <a:rPr lang="en-US" altLang="zh-CN" sz="3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in young or aged MSCs. Then, Tukey’s post-hoc tests were proceeded to confirm the mean difference between the bars. (**** </a:t>
            </a:r>
            <a:r>
              <a:rPr lang="en-US" altLang="zh-CN" sz="36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3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&lt; 0.0001, *** </a:t>
            </a:r>
            <a:r>
              <a:rPr lang="en-US" altLang="zh-CN" sz="36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3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&lt; 0.001, **</a:t>
            </a:r>
            <a:r>
              <a:rPr lang="en-US" altLang="zh-CN" sz="36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</a:t>
            </a:r>
            <a:r>
              <a:rPr lang="en-US" altLang="zh-CN" sz="3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&lt; 0.01, n = 3).</a:t>
            </a:r>
            <a:endParaRPr lang="zh-CN" altLang="zh-CN" sz="36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60237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Object 5">
            <a:extLst>
              <a:ext uri="{FF2B5EF4-FFF2-40B4-BE49-F238E27FC236}">
                <a16:creationId xmlns:a16="http://schemas.microsoft.com/office/drawing/2014/main" id="{603D11B9-34E9-8A97-D190-4B5DE50A8E8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6938481"/>
              </p:ext>
            </p:extLst>
          </p:nvPr>
        </p:nvGraphicFramePr>
        <p:xfrm>
          <a:off x="3281363" y="5734050"/>
          <a:ext cx="14801850" cy="9372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3700034" imgH="2343522" progId="Prism9.Document">
                  <p:embed/>
                </p:oleObj>
              </mc:Choice>
              <mc:Fallback>
                <p:oleObj name="Prism 9" r:id="rId3" imgW="3700034" imgH="2343522" progId="Prism9.Document">
                  <p:embed/>
                  <p:pic>
                    <p:nvPicPr>
                      <p:cNvPr id="7" name="Object 5">
                        <a:extLst>
                          <a:ext uri="{FF2B5EF4-FFF2-40B4-BE49-F238E27FC236}">
                            <a16:creationId xmlns:a16="http://schemas.microsoft.com/office/drawing/2014/main" id="{603D11B9-34E9-8A97-D190-4B5DE50A8E8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281363" y="5734050"/>
                        <a:ext cx="14801850" cy="9372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" name="Group 1">
            <a:extLst>
              <a:ext uri="{FF2B5EF4-FFF2-40B4-BE49-F238E27FC236}">
                <a16:creationId xmlns:a16="http://schemas.microsoft.com/office/drawing/2014/main" id="{461714C3-9468-4EF8-997F-52B11EB5132D}"/>
              </a:ext>
            </a:extLst>
          </p:cNvPr>
          <p:cNvGrpSpPr/>
          <p:nvPr/>
        </p:nvGrpSpPr>
        <p:grpSpPr>
          <a:xfrm>
            <a:off x="7659038" y="6122172"/>
            <a:ext cx="7158098" cy="1194376"/>
            <a:chOff x="1360154" y="734915"/>
            <a:chExt cx="1210420" cy="298594"/>
          </a:xfrm>
        </p:grpSpPr>
        <p:cxnSp>
          <p:nvCxnSpPr>
            <p:cNvPr id="8" name="Straight Connector 14">
              <a:extLst>
                <a:ext uri="{FF2B5EF4-FFF2-40B4-BE49-F238E27FC236}">
                  <a16:creationId xmlns:a16="http://schemas.microsoft.com/office/drawing/2014/main" id="{397FC78E-3639-AFCB-7580-D08418DCAD8C}"/>
                </a:ext>
              </a:extLst>
            </p:cNvPr>
            <p:cNvCxnSpPr>
              <a:cxnSpLocks/>
            </p:cNvCxnSpPr>
            <p:nvPr/>
          </p:nvCxnSpPr>
          <p:spPr>
            <a:xfrm>
              <a:off x="1784842" y="880152"/>
              <a:ext cx="713120" cy="0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9" name="TextBox 15">
              <a:extLst>
                <a:ext uri="{FF2B5EF4-FFF2-40B4-BE49-F238E27FC236}">
                  <a16:creationId xmlns:a16="http://schemas.microsoft.com/office/drawing/2014/main" id="{BA5A364F-92D4-FBDA-6CD8-5F5FB3D5EDCF}"/>
                </a:ext>
              </a:extLst>
            </p:cNvPr>
            <p:cNvSpPr txBox="1"/>
            <p:nvPr/>
          </p:nvSpPr>
          <p:spPr>
            <a:xfrm>
              <a:off x="1784843" y="734915"/>
              <a:ext cx="713120" cy="1461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**</a:t>
              </a:r>
            </a:p>
          </p:txBody>
        </p:sp>
        <p:cxnSp>
          <p:nvCxnSpPr>
            <p:cNvPr id="10" name="Straight Connector 17">
              <a:extLst>
                <a:ext uri="{FF2B5EF4-FFF2-40B4-BE49-F238E27FC236}">
                  <a16:creationId xmlns:a16="http://schemas.microsoft.com/office/drawing/2014/main" id="{7A6C1AE2-0B18-1859-3214-CB415FE4504D}"/>
                </a:ext>
              </a:extLst>
            </p:cNvPr>
            <p:cNvCxnSpPr>
              <a:cxnSpLocks/>
            </p:cNvCxnSpPr>
            <p:nvPr/>
          </p:nvCxnSpPr>
          <p:spPr>
            <a:xfrm>
              <a:off x="1360154" y="1032552"/>
              <a:ext cx="713120" cy="0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1" name="TextBox 18">
              <a:extLst>
                <a:ext uri="{FF2B5EF4-FFF2-40B4-BE49-F238E27FC236}">
                  <a16:creationId xmlns:a16="http://schemas.microsoft.com/office/drawing/2014/main" id="{F3C23E8C-DC43-853F-1264-4690834544F3}"/>
                </a:ext>
              </a:extLst>
            </p:cNvPr>
            <p:cNvSpPr txBox="1"/>
            <p:nvPr/>
          </p:nvSpPr>
          <p:spPr>
            <a:xfrm>
              <a:off x="1360155" y="887315"/>
              <a:ext cx="713120" cy="1461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**</a:t>
              </a:r>
            </a:p>
          </p:txBody>
        </p:sp>
        <p:cxnSp>
          <p:nvCxnSpPr>
            <p:cNvPr id="12" name="Straight Connector 19">
              <a:extLst>
                <a:ext uri="{FF2B5EF4-FFF2-40B4-BE49-F238E27FC236}">
                  <a16:creationId xmlns:a16="http://schemas.microsoft.com/office/drawing/2014/main" id="{34C83B6F-5B7D-EF84-D98F-D2B3DDAE247B}"/>
                </a:ext>
              </a:extLst>
            </p:cNvPr>
            <p:cNvCxnSpPr>
              <a:cxnSpLocks/>
            </p:cNvCxnSpPr>
            <p:nvPr/>
          </p:nvCxnSpPr>
          <p:spPr>
            <a:xfrm>
              <a:off x="2176462" y="1032552"/>
              <a:ext cx="321499" cy="0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TextBox 20">
              <a:extLst>
                <a:ext uri="{FF2B5EF4-FFF2-40B4-BE49-F238E27FC236}">
                  <a16:creationId xmlns:a16="http://schemas.microsoft.com/office/drawing/2014/main" id="{4619BD4D-1CCD-2474-5F36-AC78EA9F282B}"/>
                </a:ext>
              </a:extLst>
            </p:cNvPr>
            <p:cNvSpPr txBox="1"/>
            <p:nvPr/>
          </p:nvSpPr>
          <p:spPr>
            <a:xfrm>
              <a:off x="2103848" y="887315"/>
              <a:ext cx="466726" cy="1461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**</a:t>
              </a:r>
            </a:p>
          </p:txBody>
        </p:sp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id="{3E01F04B-CD98-48B7-B1DC-E7746924F9B3}"/>
              </a:ext>
            </a:extLst>
          </p:cNvPr>
          <p:cNvGrpSpPr/>
          <p:nvPr/>
        </p:nvGrpSpPr>
        <p:grpSpPr>
          <a:xfrm>
            <a:off x="17193935" y="6276869"/>
            <a:ext cx="1381908" cy="1582400"/>
            <a:chOff x="3962672" y="425010"/>
            <a:chExt cx="345477" cy="395600"/>
          </a:xfrm>
        </p:grpSpPr>
        <p:sp>
          <p:nvSpPr>
            <p:cNvPr id="22" name="Rectangle 10">
              <a:extLst>
                <a:ext uri="{FF2B5EF4-FFF2-40B4-BE49-F238E27FC236}">
                  <a16:creationId xmlns:a16="http://schemas.microsoft.com/office/drawing/2014/main" id="{AA8F4ED2-15CF-420C-8758-E591FFE62EC6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962672" y="452159"/>
              <a:ext cx="122675" cy="122675"/>
            </a:xfrm>
            <a:prstGeom prst="rect">
              <a:avLst/>
            </a:prstGeom>
            <a:solidFill>
              <a:schemeClr val="bg1"/>
            </a:solidFill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 sz="4000" dirty="0"/>
            </a:p>
          </p:txBody>
        </p:sp>
        <p:sp>
          <p:nvSpPr>
            <p:cNvPr id="23" name="Rectangle 11">
              <a:extLst>
                <a:ext uri="{FF2B5EF4-FFF2-40B4-BE49-F238E27FC236}">
                  <a16:creationId xmlns:a16="http://schemas.microsoft.com/office/drawing/2014/main" id="{53312E9C-9A2F-4E1A-86B7-538F4813E2F4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962672" y="670787"/>
              <a:ext cx="122675" cy="122675"/>
            </a:xfrm>
            <a:prstGeom prst="rect">
              <a:avLst/>
            </a:prstGeom>
            <a:solidFill>
              <a:srgbClr val="EBC2F8"/>
            </a:solidFill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 sz="4000" dirty="0"/>
            </a:p>
          </p:txBody>
        </p:sp>
        <p:sp>
          <p:nvSpPr>
            <p:cNvPr id="25" name="TextBox 13">
              <a:extLst>
                <a:ext uri="{FF2B5EF4-FFF2-40B4-BE49-F238E27FC236}">
                  <a16:creationId xmlns:a16="http://schemas.microsoft.com/office/drawing/2014/main" id="{B7D74A7A-E604-404E-9FAE-F297D9829C9C}"/>
                </a:ext>
              </a:extLst>
            </p:cNvPr>
            <p:cNvSpPr txBox="1"/>
            <p:nvPr/>
          </p:nvSpPr>
          <p:spPr>
            <a:xfrm>
              <a:off x="4083648" y="425010"/>
              <a:ext cx="224501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4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0</a:t>
              </a:r>
              <a:endParaRPr lang="en-JP" sz="4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14">
              <a:extLst>
                <a:ext uri="{FF2B5EF4-FFF2-40B4-BE49-F238E27FC236}">
                  <a16:creationId xmlns:a16="http://schemas.microsoft.com/office/drawing/2014/main" id="{C937BFD9-4493-44D0-B540-7BDFF0EC47F5}"/>
                </a:ext>
              </a:extLst>
            </p:cNvPr>
            <p:cNvSpPr txBox="1"/>
            <p:nvPr/>
          </p:nvSpPr>
          <p:spPr>
            <a:xfrm>
              <a:off x="4083648" y="643638"/>
              <a:ext cx="224501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4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1</a:t>
              </a: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5B2601CE-DE7B-CA67-97F9-EC8665D3A070}"/>
              </a:ext>
            </a:extLst>
          </p:cNvPr>
          <p:cNvSpPr txBox="1"/>
          <p:nvPr/>
        </p:nvSpPr>
        <p:spPr>
          <a:xfrm>
            <a:off x="23024691" y="37964970"/>
            <a:ext cx="378057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JP" sz="4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</a:p>
        </p:txBody>
      </p:sp>
      <p:graphicFrame>
        <p:nvGraphicFramePr>
          <p:cNvPr id="19" name="Table 18">
            <a:extLst>
              <a:ext uri="{FF2B5EF4-FFF2-40B4-BE49-F238E27FC236}">
                <a16:creationId xmlns:a16="http://schemas.microsoft.com/office/drawing/2014/main" id="{992D4D3B-360A-4237-ACA9-762E1B2C8B1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47337831"/>
              </p:ext>
            </p:extLst>
          </p:nvPr>
        </p:nvGraphicFramePr>
        <p:xfrm>
          <a:off x="2533572" y="1659030"/>
          <a:ext cx="22789209" cy="4013280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5185950">
                  <a:extLst>
                    <a:ext uri="{9D8B030D-6E8A-4147-A177-3AD203B41FA5}">
                      <a16:colId xmlns:a16="http://schemas.microsoft.com/office/drawing/2014/main" val="2046327993"/>
                    </a:ext>
                  </a:extLst>
                </a:gridCol>
                <a:gridCol w="4058586">
                  <a:extLst>
                    <a:ext uri="{9D8B030D-6E8A-4147-A177-3AD203B41FA5}">
                      <a16:colId xmlns:a16="http://schemas.microsoft.com/office/drawing/2014/main" val="867884037"/>
                    </a:ext>
                  </a:extLst>
                </a:gridCol>
                <a:gridCol w="2296587">
                  <a:extLst>
                    <a:ext uri="{9D8B030D-6E8A-4147-A177-3AD203B41FA5}">
                      <a16:colId xmlns:a16="http://schemas.microsoft.com/office/drawing/2014/main" val="2882707498"/>
                    </a:ext>
                  </a:extLst>
                </a:gridCol>
                <a:gridCol w="3270895">
                  <a:extLst>
                    <a:ext uri="{9D8B030D-6E8A-4147-A177-3AD203B41FA5}">
                      <a16:colId xmlns:a16="http://schemas.microsoft.com/office/drawing/2014/main" val="2369536273"/>
                    </a:ext>
                  </a:extLst>
                </a:gridCol>
                <a:gridCol w="4975939">
                  <a:extLst>
                    <a:ext uri="{9D8B030D-6E8A-4147-A177-3AD203B41FA5}">
                      <a16:colId xmlns:a16="http://schemas.microsoft.com/office/drawing/2014/main" val="835850434"/>
                    </a:ext>
                  </a:extLst>
                </a:gridCol>
                <a:gridCol w="3001252">
                  <a:extLst>
                    <a:ext uri="{9D8B030D-6E8A-4147-A177-3AD203B41FA5}">
                      <a16:colId xmlns:a16="http://schemas.microsoft.com/office/drawing/2014/main" val="1663211205"/>
                    </a:ext>
                  </a:extLst>
                </a:gridCol>
              </a:tblGrid>
              <a:tr h="712876"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9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ANOVA table</a:t>
                      </a:r>
                    </a:p>
                  </a:txBody>
                  <a:tcPr marL="32305" marR="32305" marT="32305" marB="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9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SS</a:t>
                      </a:r>
                    </a:p>
                  </a:txBody>
                  <a:tcPr marL="32305" marR="32305" marT="323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9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DF</a:t>
                      </a:r>
                    </a:p>
                  </a:txBody>
                  <a:tcPr marL="32305" marR="32305" marT="323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9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MS</a:t>
                      </a:r>
                    </a:p>
                  </a:txBody>
                  <a:tcPr marL="32305" marR="32305" marT="323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9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</a:t>
                      </a:r>
                      <a:r>
                        <a:rPr lang="en-US" sz="3900" b="1" i="0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DFn</a:t>
                      </a:r>
                      <a:r>
                        <a:rPr lang="en-US" sz="39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, </a:t>
                      </a:r>
                      <a:r>
                        <a:rPr lang="en-US" sz="3900" b="1" i="0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DFd</a:t>
                      </a:r>
                      <a:r>
                        <a:rPr lang="en-US" sz="39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)</a:t>
                      </a:r>
                    </a:p>
                  </a:txBody>
                  <a:tcPr marL="32305" marR="32305" marT="323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900" b="1" i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P</a:t>
                      </a:r>
                      <a:r>
                        <a:rPr lang="en-US" altLang="zh-CN" sz="39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 value</a:t>
                      </a:r>
                    </a:p>
                  </a:txBody>
                  <a:tcPr marL="32305" marR="32305" marT="32305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18543849"/>
                  </a:ext>
                </a:extLst>
              </a:tr>
              <a:tr h="825101"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5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Macrophage</a:t>
                      </a:r>
                      <a:endParaRPr lang="en-US" sz="35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32305" marR="32305" marT="32305" marB="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5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07.6</a:t>
                      </a:r>
                    </a:p>
                  </a:txBody>
                  <a:tcPr marL="11747" marR="11747" marT="11747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5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</a:t>
                      </a:r>
                    </a:p>
                  </a:txBody>
                  <a:tcPr marL="11747" marR="11747" marT="11747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5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07.6</a:t>
                      </a:r>
                    </a:p>
                  </a:txBody>
                  <a:tcPr marL="11747" marR="11747" marT="11747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5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1, 8) = 842.4</a:t>
                      </a:r>
                    </a:p>
                  </a:txBody>
                  <a:tcPr marL="11747" marR="11747" marT="11747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5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</a:p>
                  </a:txBody>
                  <a:tcPr marL="11747" marR="11747" marT="11747" marB="0" anchor="b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11933949"/>
                  </a:ext>
                </a:extLst>
              </a:tr>
              <a:tr h="825101"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5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Age</a:t>
                      </a:r>
                    </a:p>
                  </a:txBody>
                  <a:tcPr marL="32305" marR="32305" marT="32305" marB="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5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8.33</a:t>
                      </a:r>
                    </a:p>
                  </a:txBody>
                  <a:tcPr marL="11747" marR="11747" marT="11747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5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</a:t>
                      </a:r>
                    </a:p>
                  </a:txBody>
                  <a:tcPr marL="11747" marR="11747" marT="11747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5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8.33</a:t>
                      </a:r>
                    </a:p>
                  </a:txBody>
                  <a:tcPr marL="11747" marR="11747" marT="11747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5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1, 8) = 74.38</a:t>
                      </a:r>
                    </a:p>
                  </a:txBody>
                  <a:tcPr marL="11747" marR="11747" marT="11747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5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</a:p>
                  </a:txBody>
                  <a:tcPr marL="11747" marR="11747" marT="11747" marB="0" anchor="b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90200619"/>
                  </a:ext>
                </a:extLst>
              </a:tr>
              <a:tr h="825101"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5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Interaction</a:t>
                      </a:r>
                    </a:p>
                  </a:txBody>
                  <a:tcPr marL="32305" marR="32305" marT="32305" marB="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5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9.61</a:t>
                      </a:r>
                    </a:p>
                  </a:txBody>
                  <a:tcPr marL="11747" marR="11747" marT="11747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5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</a:t>
                      </a:r>
                    </a:p>
                  </a:txBody>
                  <a:tcPr marL="11747" marR="11747" marT="11747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5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9.61</a:t>
                      </a:r>
                    </a:p>
                  </a:txBody>
                  <a:tcPr marL="11747" marR="11747" marT="11747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5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1, 8) = 79.61</a:t>
                      </a:r>
                    </a:p>
                  </a:txBody>
                  <a:tcPr marL="11747" marR="11747" marT="11747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35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</a:p>
                  </a:txBody>
                  <a:tcPr marL="32305" marR="32305" marT="32305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46311931"/>
                  </a:ext>
                </a:extLst>
              </a:tr>
              <a:tr h="825101">
                <a:tc gridSpan="6">
                  <a:txBody>
                    <a:bodyPr/>
                    <a:lstStyle/>
                    <a:p>
                      <a:pPr marL="0" marR="0" lvl="0" indent="0" algn="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: Sum-of-squares    DF: Degrees of freedom    MS: Mean </a:t>
                      </a:r>
                      <a:r>
                        <a:rPr lang="en-US" altLang="zh-CN" sz="36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quares    </a:t>
                      </a:r>
                      <a:r>
                        <a:rPr lang="en-US" altLang="zh-CN" sz="3600" b="0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Fn</a:t>
                      </a:r>
                      <a:r>
                        <a:rPr lang="en-US" altLang="zh-CN" sz="36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: DF in numerator    </a:t>
                      </a:r>
                      <a:r>
                        <a:rPr lang="en-US" altLang="zh-CN" sz="3600" b="0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Fd</a:t>
                      </a:r>
                      <a:r>
                        <a:rPr lang="en-US" altLang="zh-CN" sz="36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: DF in denominator</a:t>
                      </a:r>
                    </a:p>
                  </a:txBody>
                  <a:tcPr marL="32305" marR="32305" marT="323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35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11747" marR="11747" marT="11747" marB="0" anchor="b"/>
                </a:tc>
                <a:tc hMerge="1"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35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11747" marR="11747" marT="11747" marB="0" anchor="b"/>
                </a:tc>
                <a:tc hMerge="1"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35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11747" marR="11747" marT="11747" marB="0" anchor="b"/>
                </a:tc>
                <a:tc hMerge="1">
                  <a:txBody>
                    <a:bodyPr/>
                    <a:lstStyle/>
                    <a:p>
                      <a:pPr marL="0" algn="ctr" defTabSz="2743200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35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11747" marR="11747" marT="11747" marB="0" anchor="b"/>
                </a:tc>
                <a:tc hMerge="1"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35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32305" marR="32305" marT="32305" marB="0" anchor="ctr"/>
                </a:tc>
                <a:extLst>
                  <a:ext uri="{0D108BD9-81ED-4DB2-BD59-A6C34878D82A}">
                    <a16:rowId xmlns:a16="http://schemas.microsoft.com/office/drawing/2014/main" val="2365662414"/>
                  </a:ext>
                </a:extLst>
              </a:tr>
            </a:tbl>
          </a:graphicData>
        </a:graphic>
      </p:graphicFrame>
      <p:sp>
        <p:nvSpPr>
          <p:cNvPr id="14" name="文本框 13">
            <a:extLst>
              <a:ext uri="{FF2B5EF4-FFF2-40B4-BE49-F238E27FC236}">
                <a16:creationId xmlns:a16="http://schemas.microsoft.com/office/drawing/2014/main" id="{B4458DE9-B3A8-331A-6A37-F653332C675A}"/>
              </a:ext>
            </a:extLst>
          </p:cNvPr>
          <p:cNvSpPr txBox="1"/>
          <p:nvPr/>
        </p:nvSpPr>
        <p:spPr>
          <a:xfrm>
            <a:off x="2533572" y="16406588"/>
            <a:ext cx="22966624" cy="43027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altLang="zh-CN" sz="36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. Aged M1 showed a higher level of </a:t>
            </a:r>
            <a:r>
              <a:rPr lang="en-US" altLang="zh-CN" sz="3600" b="1" i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s</a:t>
            </a:r>
            <a:r>
              <a:rPr lang="en-US" altLang="zh-CN" sz="36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xpression.</a:t>
            </a:r>
            <a:r>
              <a:rPr lang="en-US" altLang="zh-CN" sz="3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one marrow-derived monocytes from 5- or 50-week mice were stimulated with 100 ng/mL M-CSF for 6 hours and then induced with 100 ng/mL LPS and 50 ng/mL </a:t>
            </a:r>
            <a:r>
              <a:rPr lang="en-US" altLang="zh-CN" sz="36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FN-</a:t>
            </a:r>
            <a:r>
              <a:rPr lang="en-US" altLang="zh-CN" sz="3600" dirty="0" err="1">
                <a:solidFill>
                  <a:srgbClr val="000000"/>
                </a:solidFill>
                <a:effectLst/>
                <a:latin typeface="Symbol" pitchFamily="2" charset="2"/>
                <a:ea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US" altLang="zh-CN" sz="36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3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 M1 for 24 hours. And the relative gene expression levels of </a:t>
            </a:r>
            <a:r>
              <a:rPr lang="en-US" altLang="zh-CN" sz="3600" i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s</a:t>
            </a:r>
            <a:r>
              <a:rPr lang="en-US" altLang="zh-CN" sz="3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macrophages were measured by real-time RT-PCR. Data are presented as mean ± standard deviation of three independent experiments. Two-way factorial ANOVA was performed to confirm statistical significance for main effects of </a:t>
            </a:r>
            <a:r>
              <a:rPr lang="en-US" altLang="zh-CN" sz="36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wo</a:t>
            </a:r>
            <a:r>
              <a:rPr lang="en-US" altLang="zh-CN" sz="3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actors (macrophage types [M0/M1] </a:t>
            </a:r>
            <a:r>
              <a:rPr lang="en-US" altLang="zh-CN" sz="36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zh-CN" altLang="en-US" sz="36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3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crophage age [young/aged]) and those interaction on relative gene expression levels of </a:t>
            </a:r>
            <a:r>
              <a:rPr lang="en-US" altLang="zh-CN" sz="3600" i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s</a:t>
            </a:r>
            <a:r>
              <a:rPr lang="en-US" altLang="zh-CN" sz="3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Then, Tukey’s post-hoc tests were proceeded to confirm the mean difference between the bars. (**** </a:t>
            </a:r>
            <a:r>
              <a:rPr lang="en-US" altLang="zh-CN" sz="36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3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36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&lt; 0.0001, </a:t>
            </a:r>
            <a:r>
              <a:rPr lang="en-US" altLang="zh-CN" sz="3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 = 3).</a:t>
            </a:r>
            <a:endParaRPr lang="zh-CN" altLang="zh-CN" sz="36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783289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01D0AF59-99C3-4251-AB9A-C966C6AD440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27432000" cy="39623996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1855405F-37A2-4869-9154-F8BE3BECE6C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1885952" y="1920240"/>
            <a:ext cx="23660100" cy="35783512"/>
          </a:xfrm>
          <a:prstGeom prst="rect">
            <a:avLst/>
          </a:prstGeom>
          <a:solidFill>
            <a:srgbClr val="FFFFFF"/>
          </a:solidFill>
          <a:ln w="9525">
            <a:noFill/>
          </a:ln>
          <a:effectLst>
            <a:outerShdw blurRad="63500" dist="17780" dir="5400000" algn="t" rotWithShape="0">
              <a:prstClr val="black">
                <a:alpha val="4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F1304043-7CF7-20AD-B053-5AE73323BD8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17624455"/>
              </p:ext>
            </p:extLst>
          </p:nvPr>
        </p:nvGraphicFramePr>
        <p:xfrm>
          <a:off x="3049216" y="6506702"/>
          <a:ext cx="21333567" cy="27851559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4702919">
                  <a:extLst>
                    <a:ext uri="{9D8B030D-6E8A-4147-A177-3AD203B41FA5}">
                      <a16:colId xmlns:a16="http://schemas.microsoft.com/office/drawing/2014/main" val="2565090328"/>
                    </a:ext>
                  </a:extLst>
                </a:gridCol>
                <a:gridCol w="3175900">
                  <a:extLst>
                    <a:ext uri="{9D8B030D-6E8A-4147-A177-3AD203B41FA5}">
                      <a16:colId xmlns:a16="http://schemas.microsoft.com/office/drawing/2014/main" val="2560922849"/>
                    </a:ext>
                  </a:extLst>
                </a:gridCol>
                <a:gridCol w="3102110">
                  <a:extLst>
                    <a:ext uri="{9D8B030D-6E8A-4147-A177-3AD203B41FA5}">
                      <a16:colId xmlns:a16="http://schemas.microsoft.com/office/drawing/2014/main" val="3125024573"/>
                    </a:ext>
                  </a:extLst>
                </a:gridCol>
                <a:gridCol w="1667055">
                  <a:extLst>
                    <a:ext uri="{9D8B030D-6E8A-4147-A177-3AD203B41FA5}">
                      <a16:colId xmlns:a16="http://schemas.microsoft.com/office/drawing/2014/main" val="2787126868"/>
                    </a:ext>
                  </a:extLst>
                </a:gridCol>
                <a:gridCol w="2588354">
                  <a:extLst>
                    <a:ext uri="{9D8B030D-6E8A-4147-A177-3AD203B41FA5}">
                      <a16:colId xmlns:a16="http://schemas.microsoft.com/office/drawing/2014/main" val="859000036"/>
                    </a:ext>
                  </a:extLst>
                </a:gridCol>
                <a:gridCol w="3803273">
                  <a:extLst>
                    <a:ext uri="{9D8B030D-6E8A-4147-A177-3AD203B41FA5}">
                      <a16:colId xmlns:a16="http://schemas.microsoft.com/office/drawing/2014/main" val="6449548"/>
                    </a:ext>
                  </a:extLst>
                </a:gridCol>
                <a:gridCol w="2293956">
                  <a:extLst>
                    <a:ext uri="{9D8B030D-6E8A-4147-A177-3AD203B41FA5}">
                      <a16:colId xmlns:a16="http://schemas.microsoft.com/office/drawing/2014/main" val="3718957319"/>
                    </a:ext>
                  </a:extLst>
                </a:gridCol>
              </a:tblGrid>
              <a:tr h="1020366"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en-US" sz="50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40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40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40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40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S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40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 (</a:t>
                      </a:r>
                      <a:r>
                        <a:rPr lang="en-US" sz="4000" b="0" i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Fn</a:t>
                      </a:r>
                      <a:r>
                        <a:rPr lang="en-US" sz="40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US" sz="4000" b="0" i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Fd</a:t>
                      </a:r>
                      <a:r>
                        <a:rPr lang="en-US" sz="40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93199412"/>
                  </a:ext>
                </a:extLst>
              </a:tr>
              <a:tr h="669027">
                <a:tc rowSpan="3"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. 1c: Bone Volume</a:t>
                      </a:r>
                      <a:endParaRPr lang="en-US" sz="50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51460" marR="251460" marT="125730" marB="12573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Time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03818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01909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12) = 19.51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002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26804011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Aging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02567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02567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1, 12) = 26.23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003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88100242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Interaction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02392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01196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12) = 12.22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013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59861603"/>
                  </a:ext>
                </a:extLst>
              </a:tr>
              <a:tr h="669027">
                <a:tc rowSpan="3"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. 1d: Regenerated bony area</a:t>
                      </a:r>
                      <a:endParaRPr lang="en-US" sz="50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51460" marR="251460" marT="125730" marB="12573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Time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1609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5804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12) = 14.85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006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44548322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Aging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8100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8100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1, 12) = 20.72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007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10407487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Interaction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6819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3409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12) = 8.722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046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47120566"/>
                  </a:ext>
                </a:extLst>
              </a:tr>
              <a:tr h="669027">
                <a:tc rowSpan="3"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. </a:t>
                      </a:r>
                      <a:r>
                        <a:rPr lang="en-US" sz="3300" b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e</a:t>
                      </a:r>
                      <a:r>
                        <a:rPr lang="en-US" sz="33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: Regenerated bony area</a:t>
                      </a:r>
                      <a:endParaRPr lang="en-US" sz="50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51460" marR="251460" marT="125730" marB="12573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Time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7679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3840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12) = 29.10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3029171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Aging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5300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5300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1, 12) = 40.17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44849243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Interaction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7886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3943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12) = 29.88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64046550"/>
                  </a:ext>
                </a:extLst>
              </a:tr>
              <a:tr h="669027">
                <a:tc rowSpan="3"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. </a:t>
                      </a:r>
                      <a:r>
                        <a:rPr lang="en-US" sz="3300" b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f</a:t>
                      </a:r>
                      <a:r>
                        <a:rPr lang="en-US" sz="33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: </a:t>
                      </a:r>
                      <a:r>
                        <a:rPr lang="en-US" sz="3300" b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unx2</a:t>
                      </a:r>
                      <a:r>
                        <a:rPr lang="en-US" sz="3300" b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33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osteoblasts</a:t>
                      </a:r>
                      <a:endParaRPr lang="en-US" sz="50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51460" marR="251460" marT="125730" marB="12573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Time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548.8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74.4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12) = 15.99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004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68123777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Aging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535.3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535.3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1, 12) = 31.19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001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38959550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Interaction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50.40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5.20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12) = 1.468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2689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39684659"/>
                  </a:ext>
                </a:extLst>
              </a:tr>
              <a:tr h="669027">
                <a:tc rowSpan="3"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. </a:t>
                      </a:r>
                      <a:r>
                        <a:rPr lang="en-US" sz="3300" b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a</a:t>
                      </a:r>
                      <a:r>
                        <a:rPr lang="en-US" sz="33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: </a:t>
                      </a:r>
                      <a:r>
                        <a:rPr lang="en-US" sz="3300" b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80</a:t>
                      </a:r>
                      <a:r>
                        <a:rPr lang="en-US" sz="3300" b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33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3300" b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1</a:t>
                      </a:r>
                      <a:endParaRPr lang="en-US" sz="50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51460" marR="251460" marT="125730" marB="12573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Time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54.</a:t>
                      </a: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6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7.03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12) = </a:t>
                      </a: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0.84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046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67586770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Aging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8.8</a:t>
                      </a: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8.8</a:t>
                      </a: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1, 12) = 8.724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299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52248764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Interaction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67.2</a:t>
                      </a: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33.60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12) = 6.066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020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35775010"/>
                  </a:ext>
                </a:extLst>
              </a:tr>
              <a:tr h="669027">
                <a:tc rowSpan="3"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. </a:t>
                      </a:r>
                      <a:r>
                        <a:rPr lang="en-US" sz="3300" b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b</a:t>
                      </a:r>
                      <a:r>
                        <a:rPr lang="en-US" sz="33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: CD206</a:t>
                      </a:r>
                      <a:r>
                        <a:rPr lang="en-US" sz="3300" b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33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2</a:t>
                      </a:r>
                      <a:endParaRPr lang="en-US" sz="50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51460" marR="251460" marT="125730" marB="12573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Time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825.4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412.7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12) = </a:t>
                      </a: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6.99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003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61845691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Aging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326.8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326.8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1, 12) = 13.46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032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0169652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Interaction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7.75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3.88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12) = 0.571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5794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23706985"/>
                  </a:ext>
                </a:extLst>
              </a:tr>
              <a:tr h="669027">
                <a:tc rowSpan="3"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. </a:t>
                      </a:r>
                      <a:r>
                        <a:rPr lang="en-US" sz="3300" b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a</a:t>
                      </a:r>
                      <a:r>
                        <a:rPr lang="en-US" sz="33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: PDGFRa</a:t>
                      </a:r>
                      <a:r>
                        <a:rPr lang="en-US" sz="3300" b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33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SCs</a:t>
                      </a:r>
                      <a:endParaRPr lang="en-US" sz="50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51460" marR="251460" marT="125730" marB="12573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Time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782.7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391.4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12) = </a:t>
                      </a: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9.76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002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58392961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Aging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29.4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29.4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1, 12) = 11.58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052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60241130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Interaction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4.514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.257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12) = 0.114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8933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34617238"/>
                  </a:ext>
                </a:extLst>
              </a:tr>
              <a:tr h="669027">
                <a:tc rowSpan="3"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. </a:t>
                      </a:r>
                      <a:r>
                        <a:rPr lang="en-US" sz="3300" b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b</a:t>
                      </a:r>
                      <a:r>
                        <a:rPr lang="en-US" sz="33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: </a:t>
                      </a:r>
                      <a:r>
                        <a:rPr lang="en-US" sz="3300" b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80</a:t>
                      </a:r>
                      <a:r>
                        <a:rPr lang="en-US" sz="3300" b="1" u="none" strike="noStrike" baseline="30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3300" b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nexinV</a:t>
                      </a:r>
                      <a:r>
                        <a:rPr lang="en-US" sz="3300" b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33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1</a:t>
                      </a:r>
                      <a:endParaRPr lang="en-US" sz="50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51460" marR="251460" marT="125730" marB="12573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Time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49.08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4.54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12) = </a:t>
                      </a: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3.54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16937015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Aging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6.623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6.623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1, 12) = 6.355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269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25999698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endParaRPr lang="en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Interaction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7.39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3.69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12) = 13.14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009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47296473"/>
                  </a:ext>
                </a:extLst>
              </a:tr>
              <a:tr h="669027">
                <a:tc rowSpan="3"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. </a:t>
                      </a:r>
                      <a:r>
                        <a:rPr lang="en-US" sz="3300" b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a</a:t>
                      </a:r>
                      <a:r>
                        <a:rPr lang="en-US" sz="33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: </a:t>
                      </a:r>
                      <a:r>
                        <a:rPr lang="en-US" altLang="zh-CN" sz="3300" b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nexinV</a:t>
                      </a:r>
                      <a:r>
                        <a:rPr lang="en-US" altLang="zh-CN" sz="3300" b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altLang="zh-CN" sz="3300" b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poptotic cells</a:t>
                      </a:r>
                      <a:endParaRPr lang="en-US" sz="3300" b="1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51460" marR="251460" marT="125730" marB="12573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Macrophage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95.7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97.84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9) = 276.9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99397734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1460" marR="251460" marT="125730" marB="12573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Condition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60.5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80.24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9) = 227.1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55138563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51460" marR="251460" marT="125730" marB="12573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Interaction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44.85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4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1.21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4, 9) = 31.73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05697119"/>
                  </a:ext>
                </a:extLst>
              </a:tr>
              <a:tr h="669027">
                <a:tc rowSpan="3"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33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. </a:t>
                      </a:r>
                      <a:r>
                        <a:rPr lang="en-US" sz="3300" b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b</a:t>
                      </a:r>
                      <a:r>
                        <a:rPr lang="en-US" sz="33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: </a:t>
                      </a:r>
                      <a:r>
                        <a:rPr lang="en-US" altLang="zh-CN" sz="3300" b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nexinV</a:t>
                      </a:r>
                      <a:r>
                        <a:rPr lang="en-US" altLang="zh-CN" sz="3300" b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altLang="zh-CN" sz="3300" b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poptotic cells</a:t>
                      </a:r>
                      <a:endParaRPr lang="en-US" altLang="zh-CN" sz="3300" b="1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51460" marR="251460" marT="125730" marB="12573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Macrophage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982.9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491.4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12) = 160.0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20159441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3300" b="1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51460" marR="251460" marT="125730" marB="12573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MSCs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4.50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4.50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1, 12) = 7.98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153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26889116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3300" b="1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51460" marR="251460" marT="125730" marB="12573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Interaction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07.7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53.87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12) = 17.53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003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00138004"/>
                  </a:ext>
                </a:extLst>
              </a:tr>
              <a:tr h="669027">
                <a:tc rowSpan="3"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33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. </a:t>
                      </a:r>
                      <a:r>
                        <a:rPr lang="en-US" sz="3300" b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c</a:t>
                      </a:r>
                      <a:r>
                        <a:rPr lang="en-US" sz="33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: </a:t>
                      </a:r>
                    </a:p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lative level of </a:t>
                      </a:r>
                      <a:r>
                        <a:rPr lang="en-US" altLang="zh-CN" sz="3300" b="1" i="1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s</a:t>
                      </a:r>
                      <a:endParaRPr lang="en-US" altLang="zh-CN" sz="3300" b="1" i="1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51460" marR="251460" marT="125730" marB="12573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Macrophage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478.3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39.2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18) = 873.8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81736421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300" b="1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51460" marR="251460" marT="125730" marB="12573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MSCs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30.05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5.03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18) = 54.89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57460081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300" b="1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51460" marR="251460" marT="125730" marB="12573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Interaction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38.28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4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9.57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4, 18) = 34.96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24319961"/>
                  </a:ext>
                </a:extLst>
              </a:tr>
              <a:tr h="669027">
                <a:tc rowSpan="3"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33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. </a:t>
                      </a:r>
                      <a:r>
                        <a:rPr lang="en-US" sz="3300" b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d</a:t>
                      </a:r>
                      <a:r>
                        <a:rPr lang="en-US" sz="33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: </a:t>
                      </a:r>
                    </a:p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lative level of </a:t>
                      </a:r>
                      <a:r>
                        <a:rPr lang="en-US" altLang="zh-CN" sz="3300" b="1" i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sl</a:t>
                      </a:r>
                      <a:endParaRPr lang="en-US" altLang="zh-CN" sz="3300" b="1" i="1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51460" marR="251460" marT="125730" marB="12573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Macrophage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2.60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3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4.20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</a:t>
                      </a: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3</a:t>
                      </a: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, 1</a:t>
                      </a: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6</a:t>
                      </a: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) = </a:t>
                      </a: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55.38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95249059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300" b="1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51460" marR="251460" marT="125730" marB="12573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MSCs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7.445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7.45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1, 16) = 98.16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20623485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300" b="1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51460" marR="251460" marT="125730" marB="12573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Interaction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.564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3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85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3, 16) = 11.27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003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58232555"/>
                  </a:ext>
                </a:extLst>
              </a:tr>
              <a:tr h="669027">
                <a:tc rowSpan="3"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33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. </a:t>
                      </a:r>
                    </a:p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lative level of </a:t>
                      </a:r>
                      <a:r>
                        <a:rPr lang="en-US" altLang="zh-CN" sz="3300" b="1" i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38</a:t>
                      </a:r>
                      <a:endParaRPr lang="en-US" altLang="zh-CN" sz="3300" b="1" i="1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51460" marR="251460" marT="125730" marB="12573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Macrophage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2.74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6.37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18) = </a:t>
                      </a: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34.60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6847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300" b="1" i="1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51460" marR="251460" marT="125730" marB="12573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MSCs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59.74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9.87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18) = 162.3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51144658"/>
                  </a:ext>
                </a:extLst>
              </a:tr>
              <a:tr h="669027">
                <a:tc vMerge="1"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300" b="1" i="1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51460" marR="251460" marT="125730" marB="125730" anchor="ctr">
                    <a:lnL>
                      <a:noFill/>
                    </a:lnL>
                    <a:lnR>
                      <a:noFill/>
                    </a:lnR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Interaction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36.72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4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9.18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4, 18) = 49.87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270380"/>
                  </a:ext>
                </a:extLst>
              </a:tr>
              <a:tr h="669027">
                <a:tc gridSpan="7">
                  <a:txBody>
                    <a:bodyPr/>
                    <a:lstStyle/>
                    <a:p>
                      <a:pPr marL="0" marR="0" lvl="0" indent="0" algn="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2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: Sum-of-squares    DF: Degrees of freedom    MS: Mean </a:t>
                      </a:r>
                      <a:r>
                        <a:rPr lang="en-US" altLang="zh-CN" sz="32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quares    </a:t>
                      </a:r>
                      <a:r>
                        <a:rPr lang="en-US" altLang="zh-CN" sz="3200" b="0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Fn</a:t>
                      </a:r>
                      <a:r>
                        <a:rPr lang="en-US" altLang="zh-CN" sz="32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: DF in numerator    </a:t>
                      </a:r>
                      <a:r>
                        <a:rPr lang="en-US" altLang="zh-CN" sz="3200" b="0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Fd</a:t>
                      </a:r>
                      <a:r>
                        <a:rPr lang="en-US" altLang="zh-CN" sz="32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: DF in denominator</a:t>
                      </a:r>
                    </a:p>
                  </a:txBody>
                  <a:tcPr marL="251460" marR="251460" marT="125730" marB="12573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/>
                </a:tc>
                <a:tc hMerge="1"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/>
                </a:tc>
                <a:tc hMerge="1"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/>
                </a:tc>
                <a:tc hMerge="1"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/>
                </a:tc>
                <a:tc hMerge="1"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26194" marR="26194" marT="26194" marB="0" anchor="ctr"/>
                </a:tc>
                <a:extLst>
                  <a:ext uri="{0D108BD9-81ED-4DB2-BD59-A6C34878D82A}">
                    <a16:rowId xmlns:a16="http://schemas.microsoft.com/office/drawing/2014/main" val="2621681247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308302B3-0669-C63E-42C7-87FD0C6B8131}"/>
              </a:ext>
            </a:extLst>
          </p:cNvPr>
          <p:cNvSpPr txBox="1"/>
          <p:nvPr/>
        </p:nvSpPr>
        <p:spPr>
          <a:xfrm>
            <a:off x="3049216" y="4388576"/>
            <a:ext cx="21230043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</a:t>
            </a:r>
            <a:r>
              <a:rPr lang="en-US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JP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JP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s</a:t>
            </a:r>
            <a:r>
              <a:rPr lang="en-JP" altLang="ja-JP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t</a:t>
            </a:r>
            <a:r>
              <a:rPr lang="en-US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-way factorial ANOVA in this study</a:t>
            </a:r>
          </a:p>
          <a:p>
            <a:r>
              <a:rPr lang="en-US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igs. 1 to 4 and Fig. 6a)</a:t>
            </a:r>
            <a:endParaRPr lang="en-JP" sz="5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Rectangle 2">
            <a:extLst>
              <a:ext uri="{FF2B5EF4-FFF2-40B4-BE49-F238E27FC236}">
                <a16:creationId xmlns:a16="http://schemas.microsoft.com/office/drawing/2014/main" id="{92AA908A-05F4-D4BA-AB9D-A85D21568920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27432000" cy="0"/>
          </a:xfrm>
          <a:prstGeom prst="rect">
            <a:avLst/>
          </a:prstGeom>
          <a:solidFill>
            <a:srgbClr val="FFFF00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0" i="0" u="sng" strike="noStrike" cap="none" normalizeH="0" baseline="0">
                <a:ln>
                  <a:noFill/>
                </a:ln>
                <a:solidFill>
                  <a:srgbClr val="008080"/>
                </a:solidFill>
                <a:effectLst/>
                <a:latin typeface="Arial" panose="020B0604020202020204" pitchFamily="34" charset="0"/>
                <a:ea typeface="Palatino Linotype" panose="02040502050505030304" pitchFamily="18" charset="0"/>
                <a:cs typeface="Times New Roman" panose="02020603050405020304" pitchFamily="18" charset="0"/>
              </a:rPr>
              <a:t>(Figs. 1 to 4 and Fig. 6a)</a:t>
            </a:r>
            <a:r>
              <a:rPr kumimoji="0" lang="en-US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 </a:t>
            </a:r>
            <a:endParaRPr kumimoji="0" lang="en-US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673955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F1304043-7CF7-20AD-B053-5AE73323BD8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15274703"/>
              </p:ext>
            </p:extLst>
          </p:nvPr>
        </p:nvGraphicFramePr>
        <p:xfrm>
          <a:off x="2628900" y="6523434"/>
          <a:ext cx="22174200" cy="24768816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6135329">
                  <a:extLst>
                    <a:ext uri="{9D8B030D-6E8A-4147-A177-3AD203B41FA5}">
                      <a16:colId xmlns:a16="http://schemas.microsoft.com/office/drawing/2014/main" val="2560922849"/>
                    </a:ext>
                  </a:extLst>
                </a:gridCol>
                <a:gridCol w="2859726">
                  <a:extLst>
                    <a:ext uri="{9D8B030D-6E8A-4147-A177-3AD203B41FA5}">
                      <a16:colId xmlns:a16="http://schemas.microsoft.com/office/drawing/2014/main" val="3125024573"/>
                    </a:ext>
                  </a:extLst>
                </a:gridCol>
                <a:gridCol w="2234608">
                  <a:extLst>
                    <a:ext uri="{9D8B030D-6E8A-4147-A177-3AD203B41FA5}">
                      <a16:colId xmlns:a16="http://schemas.microsoft.com/office/drawing/2014/main" val="2787126868"/>
                    </a:ext>
                  </a:extLst>
                </a:gridCol>
                <a:gridCol w="3182624">
                  <a:extLst>
                    <a:ext uri="{9D8B030D-6E8A-4147-A177-3AD203B41FA5}">
                      <a16:colId xmlns:a16="http://schemas.microsoft.com/office/drawing/2014/main" val="859000036"/>
                    </a:ext>
                  </a:extLst>
                </a:gridCol>
                <a:gridCol w="4841654">
                  <a:extLst>
                    <a:ext uri="{9D8B030D-6E8A-4147-A177-3AD203B41FA5}">
                      <a16:colId xmlns:a16="http://schemas.microsoft.com/office/drawing/2014/main" val="6449548"/>
                    </a:ext>
                  </a:extLst>
                </a:gridCol>
                <a:gridCol w="2920259">
                  <a:extLst>
                    <a:ext uri="{9D8B030D-6E8A-4147-A177-3AD203B41FA5}">
                      <a16:colId xmlns:a16="http://schemas.microsoft.com/office/drawing/2014/main" val="3718957319"/>
                    </a:ext>
                  </a:extLst>
                </a:gridCol>
              </a:tblGrid>
              <a:tr h="1032034"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40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40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40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40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S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40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 (</a:t>
                      </a:r>
                      <a:r>
                        <a:rPr lang="en-US" sz="4000" b="0" i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Fn</a:t>
                      </a:r>
                      <a:r>
                        <a:rPr lang="en-US" sz="40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US" sz="4000" b="0" i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Fd</a:t>
                      </a:r>
                      <a:r>
                        <a:rPr lang="en-US" sz="40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93199412"/>
                  </a:ext>
                </a:extLst>
              </a:tr>
              <a:tr h="1032034"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lative level of </a:t>
                      </a:r>
                      <a:r>
                        <a:rPr lang="en-US" altLang="zh-CN" sz="3300" b="1" i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6</a:t>
                      </a:r>
                      <a:endParaRPr lang="en-US" altLang="zh-CN" sz="3300" b="1" i="1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.184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5918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6) = 104.7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33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26804011"/>
                  </a:ext>
                </a:extLst>
              </a:tr>
              <a:tr h="1032034"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33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elative level of </a:t>
                      </a:r>
                      <a:r>
                        <a:rPr kumimoji="0" lang="en-US" altLang="zh-CN" sz="3300" b="1" i="1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iNos</a:t>
                      </a:r>
                      <a:endParaRPr kumimoji="0" lang="en-US" altLang="zh-CN" sz="3300" b="1" i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3364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168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6) = 92.99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33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  <a:endParaRPr kumimoji="0" lang="en-US" sz="33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88100242"/>
                  </a:ext>
                </a:extLst>
              </a:tr>
              <a:tr h="1032034"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33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elative level of </a:t>
                      </a:r>
                      <a:r>
                        <a:rPr kumimoji="0" lang="en-US" altLang="zh-CN" sz="3300" b="1" i="1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nf</a:t>
                      </a:r>
                      <a:r>
                        <a:rPr kumimoji="0" lang="en-US" altLang="zh-CN" sz="3300" b="1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kumimoji="0" lang="en-US" altLang="ja-JP" sz="3300" b="1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α</a:t>
                      </a:r>
                      <a:endParaRPr kumimoji="0" lang="en-US" altLang="zh-CN" sz="3300" b="1" i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6078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3039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6) = 72.73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59861603"/>
                  </a:ext>
                </a:extLst>
              </a:tr>
              <a:tr h="1032034"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33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elative level of </a:t>
                      </a:r>
                      <a:r>
                        <a:rPr kumimoji="0" lang="en-US" altLang="zh-CN" sz="3300" b="1" i="1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Nf-κb</a:t>
                      </a:r>
                      <a:endParaRPr kumimoji="0" lang="en-US" altLang="zh-CN" sz="3300" b="1" i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.633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3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5445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3, 8) = 16.73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008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44548322"/>
                  </a:ext>
                </a:extLst>
              </a:tr>
              <a:tr h="1032034"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33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elative level of </a:t>
                      </a:r>
                      <a:r>
                        <a:rPr kumimoji="0" lang="en-US" altLang="zh-CN" sz="3300" b="1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rg-1</a:t>
                      </a:r>
                      <a:endParaRPr kumimoji="0" lang="en-US" altLang="zh-CN" sz="3300" b="1" i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b" latinLnBrk="0" hangingPunct="1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155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b" latinLnBrk="0" hangingPunct="1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b" latinLnBrk="0" hangingPunct="1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078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b" latinLnBrk="0" hangingPunct="1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6) = 160.5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b" latinLnBrk="0" hangingPunct="1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10407487"/>
                  </a:ext>
                </a:extLst>
              </a:tr>
              <a:tr h="1032034"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33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elative level of </a:t>
                      </a:r>
                      <a:r>
                        <a:rPr kumimoji="0" lang="en-US" altLang="zh-CN" sz="3300" b="1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Ym-1</a:t>
                      </a:r>
                      <a:endParaRPr kumimoji="0" lang="en-US" altLang="zh-CN" sz="3300" b="1" i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b" latinLnBrk="0" hangingPunct="1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7.09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b" latinLnBrk="0" hangingPunct="1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b" latinLnBrk="0" hangingPunct="1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8.543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b" latinLnBrk="0" hangingPunct="1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6) = 62.14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b" latinLnBrk="0" hangingPunct="1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47120566"/>
                  </a:ext>
                </a:extLst>
              </a:tr>
              <a:tr h="1032034"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lative level of </a:t>
                      </a:r>
                      <a:r>
                        <a:rPr lang="en-US" altLang="zh-CN" sz="3300" b="1" i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zz-1</a:t>
                      </a:r>
                      <a:endParaRPr lang="en-US" altLang="zh-CN" sz="3300" b="1" i="1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b" latinLnBrk="0" hangingPunct="1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4.54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b" latinLnBrk="0" hangingPunct="1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b" latinLnBrk="0" hangingPunct="1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2.27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b" latinLnBrk="0" hangingPunct="1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6) = 94.38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2743200" rtl="0" eaLnBrk="1" fontAlgn="b" latinLnBrk="0" hangingPunct="1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3029171"/>
                  </a:ext>
                </a:extLst>
              </a:tr>
              <a:tr h="1032034"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lative level of </a:t>
                      </a:r>
                      <a:r>
                        <a:rPr lang="en-US" altLang="zh-CN" sz="3300" b="1" i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6</a:t>
                      </a:r>
                      <a:endParaRPr lang="en-US" altLang="zh-CN" sz="3300" b="1" i="1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.669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.334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6) = 13.85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056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44849243"/>
                  </a:ext>
                </a:extLst>
              </a:tr>
              <a:tr h="1032034"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33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elative level of </a:t>
                      </a:r>
                      <a:r>
                        <a:rPr kumimoji="0" lang="en-US" altLang="zh-CN" sz="3300" b="1" i="1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iNos</a:t>
                      </a:r>
                      <a:endParaRPr kumimoji="0" lang="en-US" altLang="zh-CN" sz="3300" b="1" i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6437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3219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6) = 6.880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280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64046550"/>
                  </a:ext>
                </a:extLst>
              </a:tr>
              <a:tr h="1032034"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33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elative level of </a:t>
                      </a:r>
                      <a:r>
                        <a:rPr kumimoji="0" lang="en-US" altLang="zh-CN" sz="3300" b="1" i="1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nf</a:t>
                      </a:r>
                      <a:r>
                        <a:rPr kumimoji="0" lang="en-US" altLang="zh-CN" sz="3300" b="1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kumimoji="0" lang="en-US" altLang="ja-JP" sz="3300" b="1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α</a:t>
                      </a:r>
                      <a:endParaRPr kumimoji="0" lang="en-US" altLang="zh-CN" sz="3300" b="1" i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2885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1443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6) = 23.58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014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68123777"/>
                  </a:ext>
                </a:extLst>
              </a:tr>
              <a:tr h="1032034"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33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elative level of </a:t>
                      </a:r>
                      <a:r>
                        <a:rPr kumimoji="0" lang="en-US" altLang="zh-CN" sz="3300" b="1" i="1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Nf-κb</a:t>
                      </a:r>
                      <a:endParaRPr kumimoji="0" lang="en-US" altLang="zh-CN" sz="3300" b="1" i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.136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568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6) = 15.63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042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38959550"/>
                  </a:ext>
                </a:extLst>
              </a:tr>
              <a:tr h="1032034"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33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elative level of </a:t>
                      </a:r>
                      <a:r>
                        <a:rPr kumimoji="0" lang="en-US" altLang="zh-CN" sz="3300" b="1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rg-1</a:t>
                      </a:r>
                      <a:endParaRPr kumimoji="0" lang="en-US" altLang="zh-CN" sz="3300" b="1" i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4.788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.394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6) = 105.8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39684659"/>
                  </a:ext>
                </a:extLst>
              </a:tr>
              <a:tr h="1032034"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33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elative level of </a:t>
                      </a:r>
                      <a:r>
                        <a:rPr kumimoji="0" lang="en-US" altLang="zh-CN" sz="3300" b="1" i="1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Ym</a:t>
                      </a:r>
                      <a:r>
                        <a:rPr kumimoji="0" lang="en-US" altLang="zh-CN" sz="3300" b="1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1</a:t>
                      </a:r>
                      <a:endParaRPr kumimoji="0" lang="en-US" altLang="zh-CN" sz="3300" b="1" i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9.104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4.55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6) = 91.12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67586770"/>
                  </a:ext>
                </a:extLst>
              </a:tr>
              <a:tr h="1032034"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lative level of </a:t>
                      </a:r>
                      <a:r>
                        <a:rPr lang="en-US" altLang="zh-CN" sz="3300" b="1" i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zz-1</a:t>
                      </a:r>
                      <a:endParaRPr lang="en-US" altLang="zh-CN" sz="3300" b="1" i="1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0.43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0.2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6) = 29.27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008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52248764"/>
                  </a:ext>
                </a:extLst>
              </a:tr>
              <a:tr h="1032034"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lative level of </a:t>
                      </a:r>
                      <a:r>
                        <a:rPr lang="en-US" altLang="zh-CN" sz="3300" b="1" i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6</a:t>
                      </a:r>
                      <a:endParaRPr lang="en-US" altLang="zh-CN" sz="3300" b="1" i="1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8847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4423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6) = 178.4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33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  <a:endParaRPr kumimoji="0" lang="en-US" sz="33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35775010"/>
                  </a:ext>
                </a:extLst>
              </a:tr>
              <a:tr h="1032034"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33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elative level of </a:t>
                      </a:r>
                      <a:r>
                        <a:rPr kumimoji="0" lang="en-US" altLang="zh-CN" sz="3300" b="1" i="1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iNos</a:t>
                      </a:r>
                      <a:endParaRPr kumimoji="0" lang="en-US" altLang="zh-CN" sz="3300" b="1" i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31081855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5540928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6) = 249.7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33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  <a:endParaRPr kumimoji="0" lang="en-US" sz="33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61845691"/>
                  </a:ext>
                </a:extLst>
              </a:tr>
              <a:tr h="1032034"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33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elative level of </a:t>
                      </a:r>
                      <a:r>
                        <a:rPr kumimoji="0" lang="en-US" altLang="zh-CN" sz="3300" b="1" i="1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nf</a:t>
                      </a:r>
                      <a:r>
                        <a:rPr kumimoji="0" lang="en-US" altLang="zh-CN" sz="3300" b="1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kumimoji="0" lang="en-US" altLang="ja-JP" sz="3300" b="1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α</a:t>
                      </a:r>
                      <a:endParaRPr kumimoji="0" lang="en-US" altLang="zh-CN" sz="3300" b="1" i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617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808.3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6) = 266.5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33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0169652"/>
                  </a:ext>
                </a:extLst>
              </a:tr>
              <a:tr h="1032034"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33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elative level of </a:t>
                      </a:r>
                      <a:r>
                        <a:rPr kumimoji="0" lang="en-US" altLang="zh-CN" sz="3300" b="1" i="1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Nf-κb</a:t>
                      </a:r>
                      <a:endParaRPr kumimoji="0" lang="en-US" altLang="zh-CN" sz="3300" b="1" i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4.26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7.129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6) = 6.848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283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23706985"/>
                  </a:ext>
                </a:extLst>
              </a:tr>
              <a:tr h="1032034"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33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elative level of </a:t>
                      </a:r>
                      <a:r>
                        <a:rPr kumimoji="0" lang="en-US" altLang="zh-CN" sz="3300" b="1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rg-1</a:t>
                      </a:r>
                      <a:endParaRPr kumimoji="0" lang="en-US" altLang="zh-CN" sz="3300" b="1" i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92.6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96.30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6) = 2277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58392961"/>
                  </a:ext>
                </a:extLst>
              </a:tr>
              <a:tr h="1032034"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33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elative level of </a:t>
                      </a:r>
                      <a:r>
                        <a:rPr kumimoji="0" lang="en-US" altLang="zh-CN" sz="3300" b="1" i="1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Ym</a:t>
                      </a:r>
                      <a:r>
                        <a:rPr kumimoji="0" lang="en-US" altLang="zh-CN" sz="3300" b="1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1</a:t>
                      </a:r>
                      <a:endParaRPr kumimoji="0" lang="en-US" altLang="zh-CN" sz="3300" b="1" i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1.123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5615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6) = 35.0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0005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60241130"/>
                  </a:ext>
                </a:extLst>
              </a:tr>
              <a:tr h="1032034"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lative level of </a:t>
                      </a:r>
                      <a:r>
                        <a:rPr lang="en-US" altLang="zh-CN" sz="3300" b="1" i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zz-1</a:t>
                      </a:r>
                      <a:endParaRPr lang="en-US" altLang="zh-CN" sz="3300" b="1" i="1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418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0.209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2, 6) = 83.49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33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34617238"/>
                  </a:ext>
                </a:extLst>
              </a:tr>
              <a:tr h="1032034">
                <a:tc>
                  <a:txBody>
                    <a:bodyPr/>
                    <a:lstStyle/>
                    <a:p>
                      <a:pPr marL="0" marR="0" lvl="0" indent="0" algn="ct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300" b="1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nexinV</a:t>
                      </a:r>
                      <a:r>
                        <a:rPr lang="en-US" altLang="zh-CN" sz="3300" b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altLang="zh-CN" sz="3300" b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poptotic cell</a:t>
                      </a:r>
                      <a:endParaRPr lang="en-US" altLang="zh-CN" sz="3300" b="1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26194" marR="26194" marT="26194" marB="0" anchor="ctr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225.6</a:t>
                      </a:r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4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56.39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3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F (4, 10) = 21.48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2743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33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+mn-cs"/>
                        </a:rPr>
                        <a:t>&lt;0.000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16937015"/>
                  </a:ext>
                </a:extLst>
              </a:tr>
              <a:tr h="1032034">
                <a:tc gridSpan="6">
                  <a:txBody>
                    <a:bodyPr/>
                    <a:lstStyle/>
                    <a:p>
                      <a:pPr marL="0" marR="0" lvl="0" indent="0" algn="r" defTabSz="2743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2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: Sum-of-squares    DF: Degrees of freedom    MS: Mean </a:t>
                      </a:r>
                      <a:r>
                        <a:rPr lang="en-US" altLang="zh-CN" sz="32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quares    </a:t>
                      </a:r>
                      <a:r>
                        <a:rPr lang="en-US" altLang="zh-CN" sz="3200" b="0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Fn</a:t>
                      </a:r>
                      <a:r>
                        <a:rPr lang="en-US" altLang="zh-CN" sz="32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: DF in numerator    </a:t>
                      </a:r>
                      <a:r>
                        <a:rPr lang="en-US" altLang="zh-CN" sz="3200" b="0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Fd</a:t>
                      </a:r>
                      <a:r>
                        <a:rPr lang="en-US" altLang="zh-CN" sz="32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: DF in denominator</a:t>
                      </a:r>
                    </a:p>
                  </a:txBody>
                  <a:tcPr marL="26194" marR="26194" marT="2619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33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33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33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33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marL="0" marR="0" lvl="0" indent="0" algn="ctr" defTabSz="2743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33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937801661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308302B3-0669-C63E-42C7-87FD0C6B8131}"/>
              </a:ext>
            </a:extLst>
          </p:cNvPr>
          <p:cNvSpPr txBox="1"/>
          <p:nvPr/>
        </p:nvSpPr>
        <p:spPr>
          <a:xfrm>
            <a:off x="2628900" y="4407491"/>
            <a:ext cx="20935155" cy="19389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</a:t>
            </a:r>
            <a:r>
              <a:rPr lang="en-US" sz="600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en-US" sz="6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JP" sz="6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6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s</a:t>
            </a:r>
            <a:r>
              <a:rPr lang="en-JP" sz="6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6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n-JP" sz="6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6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e</a:t>
            </a:r>
            <a:r>
              <a:rPr lang="en-JP" sz="6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way ANOVA </a:t>
            </a:r>
            <a:r>
              <a:rPr lang="en-US" sz="6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this study</a:t>
            </a:r>
          </a:p>
          <a:p>
            <a:r>
              <a:rPr lang="en-US" sz="6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igs. 5 and 6)</a:t>
            </a:r>
            <a:endParaRPr lang="en-JP" sz="6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20550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648</TotalTime>
  <Words>2199</Words>
  <Application>Microsoft Office PowerPoint</Application>
  <PresentationFormat>Custom</PresentationFormat>
  <Paragraphs>626</Paragraphs>
  <Slides>6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6</vt:i4>
      </vt:variant>
    </vt:vector>
  </HeadingPairs>
  <TitlesOfParts>
    <vt:vector size="16" baseType="lpstr">
      <vt:lpstr>等线</vt:lpstr>
      <vt:lpstr>Arial</vt:lpstr>
      <vt:lpstr>Calibri</vt:lpstr>
      <vt:lpstr>Calibri Light</vt:lpstr>
      <vt:lpstr>Palatino Linotype</vt:lpstr>
      <vt:lpstr>Symbol</vt:lpstr>
      <vt:lpstr>Times New Roman</vt:lpstr>
      <vt:lpstr>Office 主题​​</vt:lpstr>
      <vt:lpstr>Prism 10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张 瓶</dc:creator>
  <cp:lastModifiedBy>MDPI</cp:lastModifiedBy>
  <cp:revision>329</cp:revision>
  <dcterms:created xsi:type="dcterms:W3CDTF">2023-01-12T04:21:41Z</dcterms:created>
  <dcterms:modified xsi:type="dcterms:W3CDTF">2024-03-13T10:06:31Z</dcterms:modified>
</cp:coreProperties>
</file>